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0972800" cy="1097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0" autoAdjust="0"/>
    <p:restoredTop sz="94660"/>
  </p:normalViewPr>
  <p:slideViewPr>
    <p:cSldViewPr snapToGrid="0">
      <p:cViewPr varScale="1">
        <p:scale>
          <a:sx n="40" d="100"/>
          <a:sy n="40" d="100"/>
        </p:scale>
        <p:origin x="2898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K:\Penalva%20Lab\paper\230323%20redo%20figures%20&amp;%20tables\raw%20data\230405_FigS7_PARP-inhibito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K:\Penalva%20Lab\paper\230323%20redo%20figures%20&amp;%20tables\raw%20data\230405_FigS7_PARP-inhibito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1658112038641928"/>
          <c:y val="4.3204641866536136E-2"/>
          <c:w val="0.63144295184654109"/>
          <c:h val="0.72382892804698973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1-FC37-4FAD-BBFC-92EF6158BB0D}"/>
              </c:ext>
            </c:extLst>
          </c:dPt>
          <c:dPt>
            <c:idx val="2"/>
            <c:invertIfNegative val="0"/>
            <c:bubble3D val="0"/>
            <c:spPr>
              <a:solidFill>
                <a:srgbClr val="ED647D"/>
              </a:solidFill>
            </c:spPr>
            <c:extLst>
              <c:ext xmlns:c16="http://schemas.microsoft.com/office/drawing/2014/chart" uri="{C3380CC4-5D6E-409C-BE32-E72D297353CC}">
                <c16:uniqueId val="{00000003-FC37-4FAD-BBFC-92EF6158BB0D}"/>
              </c:ext>
            </c:extLst>
          </c:dPt>
          <c:dPt>
            <c:idx val="3"/>
            <c:invertIfNegative val="0"/>
            <c:bubble3D val="0"/>
            <c:spPr>
              <a:solidFill>
                <a:srgbClr val="9BBB59"/>
              </a:solidFill>
            </c:spPr>
            <c:extLst>
              <c:ext xmlns:c16="http://schemas.microsoft.com/office/drawing/2014/chart" uri="{C3380CC4-5D6E-409C-BE32-E72D297353CC}">
                <c16:uniqueId val="{00000005-FC37-4FAD-BBFC-92EF6158BB0D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17:$F$17</c:f>
                <c:numCache>
                  <c:formatCode>General</c:formatCode>
                  <c:ptCount val="4"/>
                  <c:pt idx="0">
                    <c:v>3.751319767761744</c:v>
                  </c:pt>
                  <c:pt idx="1">
                    <c:v>2.5044160996128424</c:v>
                  </c:pt>
                  <c:pt idx="2">
                    <c:v>5.224136292249657</c:v>
                  </c:pt>
                  <c:pt idx="3">
                    <c:v>1.6587043136134916</c:v>
                  </c:pt>
                </c:numCache>
              </c:numRef>
            </c:plus>
            <c:minus>
              <c:numRef>
                <c:f>Sheet2!$C$17:$F$17</c:f>
                <c:numCache>
                  <c:formatCode>General</c:formatCode>
                  <c:ptCount val="4"/>
                  <c:pt idx="0">
                    <c:v>3.751319767761744</c:v>
                  </c:pt>
                  <c:pt idx="1">
                    <c:v>2.5044160996128424</c:v>
                  </c:pt>
                  <c:pt idx="2">
                    <c:v>5.224136292249657</c:v>
                  </c:pt>
                  <c:pt idx="3">
                    <c:v>1.6587043136134916</c:v>
                  </c:pt>
                </c:numCache>
              </c:numRef>
            </c:minus>
            <c:spPr>
              <a:ln w="12700"/>
            </c:spPr>
          </c:errBars>
          <c:cat>
            <c:strRef>
              <c:f>Sheet2!$C$1:$F$1</c:f>
              <c:strCache>
                <c:ptCount val="4"/>
                <c:pt idx="0">
                  <c:v>siCTRL</c:v>
                </c:pt>
                <c:pt idx="1">
                  <c:v>siSERBP1</c:v>
                </c:pt>
                <c:pt idx="2">
                  <c:v>siCTRL + PJ34</c:v>
                </c:pt>
                <c:pt idx="3">
                  <c:v>siSERBP1 + PJ34</c:v>
                </c:pt>
              </c:strCache>
            </c:strRef>
          </c:cat>
          <c:val>
            <c:numRef>
              <c:f>Sheet2!$C$16:$F$16</c:f>
              <c:numCache>
                <c:formatCode>General</c:formatCode>
                <c:ptCount val="4"/>
                <c:pt idx="0">
                  <c:v>93.179999999999993</c:v>
                </c:pt>
                <c:pt idx="1">
                  <c:v>37.844999999999999</c:v>
                </c:pt>
                <c:pt idx="2">
                  <c:v>80.88000000000001</c:v>
                </c:pt>
                <c:pt idx="3">
                  <c:v>27.9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C37-4FAD-BBFC-92EF6158BB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6"/>
        <c:axId val="47495808"/>
        <c:axId val="47497600"/>
      </c:barChart>
      <c:catAx>
        <c:axId val="47495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1740000" anchor="b" anchorCtr="1"/>
          <a:lstStyle/>
          <a:p>
            <a:pPr>
              <a:defRPr sz="1400"/>
            </a:pPr>
            <a:endParaRPr lang="en-US"/>
          </a:p>
        </c:txPr>
        <c:crossAx val="47497600"/>
        <c:crosses val="autoZero"/>
        <c:auto val="1"/>
        <c:lblAlgn val="ctr"/>
        <c:lblOffset val="100"/>
        <c:noMultiLvlLbl val="0"/>
      </c:catAx>
      <c:valAx>
        <c:axId val="47497600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de-DE"/>
                  <a:t>% Confluence at 100h</a:t>
                </a:r>
              </a:p>
            </c:rich>
          </c:tx>
          <c:layout>
            <c:manualLayout>
              <c:xMode val="edge"/>
              <c:yMode val="edge"/>
              <c:x val="8.1014273338265927E-2"/>
              <c:y val="0.1921033202806330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474958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1658112038641928"/>
          <c:y val="4.3204641866536136E-2"/>
          <c:w val="0.63144295184654109"/>
          <c:h val="0.72382892804698973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1-77AF-4420-A783-C79AA54B58CC}"/>
              </c:ext>
            </c:extLst>
          </c:dPt>
          <c:dPt>
            <c:idx val="2"/>
            <c:invertIfNegative val="0"/>
            <c:bubble3D val="0"/>
            <c:spPr>
              <a:solidFill>
                <a:srgbClr val="ED647D"/>
              </a:solidFill>
            </c:spPr>
            <c:extLst>
              <c:ext xmlns:c16="http://schemas.microsoft.com/office/drawing/2014/chart" uri="{C3380CC4-5D6E-409C-BE32-E72D297353CC}">
                <c16:uniqueId val="{00000003-77AF-4420-A783-C79AA54B58CC}"/>
              </c:ext>
            </c:extLst>
          </c:dPt>
          <c:dPt>
            <c:idx val="3"/>
            <c:invertIfNegative val="0"/>
            <c:bubble3D val="0"/>
            <c:spPr>
              <a:solidFill>
                <a:srgbClr val="9BBB59"/>
              </a:solidFill>
            </c:spPr>
            <c:extLst>
              <c:ext xmlns:c16="http://schemas.microsoft.com/office/drawing/2014/chart" uri="{C3380CC4-5D6E-409C-BE32-E72D297353CC}">
                <c16:uniqueId val="{00000005-77AF-4420-A783-C79AA54B58CC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C$19:$F$19</c:f>
                <c:numCache>
                  <c:formatCode>General</c:formatCode>
                  <c:ptCount val="4"/>
                  <c:pt idx="0">
                    <c:v>0.65223120000000001</c:v>
                  </c:pt>
                  <c:pt idx="1">
                    <c:v>9.5597879999999993</c:v>
                  </c:pt>
                  <c:pt idx="2">
                    <c:v>0.7854139</c:v>
                  </c:pt>
                  <c:pt idx="3">
                    <c:v>5.2649350000000004</c:v>
                  </c:pt>
                </c:numCache>
              </c:numRef>
            </c:plus>
            <c:minus>
              <c:numRef>
                <c:f>Sheet2!$C$19:$F$19</c:f>
                <c:numCache>
                  <c:formatCode>General</c:formatCode>
                  <c:ptCount val="4"/>
                  <c:pt idx="0">
                    <c:v>0.65223120000000001</c:v>
                  </c:pt>
                  <c:pt idx="1">
                    <c:v>9.5597879999999993</c:v>
                  </c:pt>
                  <c:pt idx="2">
                    <c:v>0.7854139</c:v>
                  </c:pt>
                  <c:pt idx="3">
                    <c:v>5.2649350000000004</c:v>
                  </c:pt>
                </c:numCache>
              </c:numRef>
            </c:minus>
            <c:spPr>
              <a:ln w="12700"/>
            </c:spPr>
          </c:errBars>
          <c:cat>
            <c:strRef>
              <c:f>Sheet2!$C$1:$F$1</c:f>
              <c:strCache>
                <c:ptCount val="4"/>
                <c:pt idx="0">
                  <c:v>siCTRL</c:v>
                </c:pt>
                <c:pt idx="1">
                  <c:v>siSERBP1</c:v>
                </c:pt>
                <c:pt idx="2">
                  <c:v>siCTRL + PJ34</c:v>
                </c:pt>
                <c:pt idx="3">
                  <c:v>siSERBP1 + PJ34</c:v>
                </c:pt>
              </c:strCache>
            </c:strRef>
          </c:cat>
          <c:val>
            <c:numRef>
              <c:f>Sheet2!$C$18:$F$18</c:f>
              <c:numCache>
                <c:formatCode>0.00000</c:formatCode>
                <c:ptCount val="4"/>
                <c:pt idx="0">
                  <c:v>93.478840000000005</c:v>
                </c:pt>
                <c:pt idx="1">
                  <c:v>69.889650000000003</c:v>
                </c:pt>
                <c:pt idx="2">
                  <c:v>83.663089999999997</c:v>
                </c:pt>
                <c:pt idx="3">
                  <c:v>41.28157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7AF-4420-A783-C79AA54B58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6"/>
        <c:axId val="47495808"/>
        <c:axId val="47497600"/>
      </c:barChart>
      <c:catAx>
        <c:axId val="47495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1740000"/>
          <a:lstStyle/>
          <a:p>
            <a:pPr>
              <a:defRPr sz="1400"/>
            </a:pPr>
            <a:endParaRPr lang="en-US"/>
          </a:p>
        </c:txPr>
        <c:crossAx val="47497600"/>
        <c:crosses val="autoZero"/>
        <c:auto val="1"/>
        <c:lblAlgn val="ctr"/>
        <c:lblOffset val="100"/>
        <c:noMultiLvlLbl val="0"/>
      </c:catAx>
      <c:valAx>
        <c:axId val="4749760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de-DE"/>
                  <a:t>% Confluence at 150h</a:t>
                </a:r>
              </a:p>
            </c:rich>
          </c:tx>
          <c:layout>
            <c:manualLayout>
              <c:xMode val="edge"/>
              <c:yMode val="edge"/>
              <c:x val="7.2821956441386559E-2"/>
              <c:y val="0.1924161771904062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474958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1795781"/>
            <a:ext cx="9326880" cy="382016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5763261"/>
            <a:ext cx="8229600" cy="2649219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956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56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1" y="584200"/>
            <a:ext cx="2366010" cy="92989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1" y="584200"/>
            <a:ext cx="6960870" cy="92989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402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68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6" y="2735583"/>
            <a:ext cx="9464040" cy="4564379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6" y="7343143"/>
            <a:ext cx="9464040" cy="2400299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963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2921000"/>
            <a:ext cx="466344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2921000"/>
            <a:ext cx="466344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341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584202"/>
            <a:ext cx="9464040" cy="2120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2689861"/>
            <a:ext cx="4642008" cy="131825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4008120"/>
            <a:ext cx="4642008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1" y="2689861"/>
            <a:ext cx="4664869" cy="1318259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1" y="4008120"/>
            <a:ext cx="4664869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98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762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970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731520"/>
            <a:ext cx="3539014" cy="256032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1579882"/>
            <a:ext cx="5554980" cy="779780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3291840"/>
            <a:ext cx="3539014" cy="6098541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74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731520"/>
            <a:ext cx="3539014" cy="256032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1579882"/>
            <a:ext cx="5554980" cy="779780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3291840"/>
            <a:ext cx="3539014" cy="6098541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069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584202"/>
            <a:ext cx="9464040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2921000"/>
            <a:ext cx="9464040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10170162"/>
            <a:ext cx="246888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A32646-608B-41BE-888C-1B9A437714F4}" type="datetimeFigureOut">
              <a:rPr lang="en-US" smtClean="0"/>
              <a:t>2/2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10170162"/>
            <a:ext cx="370332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10170162"/>
            <a:ext cx="246888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332856-29B3-443A-8DCA-224CE03E68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171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7.jpeg"/><Relationship Id="rId18" Type="http://schemas.microsoft.com/office/2007/relationships/hdphoto" Target="../media/hdphoto5.wdp"/><Relationship Id="rId3" Type="http://schemas.openxmlformats.org/officeDocument/2006/relationships/chart" Target="../charts/chart2.xml"/><Relationship Id="rId7" Type="http://schemas.microsoft.com/office/2007/relationships/hdphoto" Target="../media/hdphoto2.wdp"/><Relationship Id="rId12" Type="http://schemas.openxmlformats.org/officeDocument/2006/relationships/image" Target="../media/image6.jpeg"/><Relationship Id="rId17" Type="http://schemas.openxmlformats.org/officeDocument/2006/relationships/image" Target="../media/image10.png"/><Relationship Id="rId2" Type="http://schemas.openxmlformats.org/officeDocument/2006/relationships/chart" Target="../charts/chart1.xml"/><Relationship Id="rId16" Type="http://schemas.openxmlformats.org/officeDocument/2006/relationships/image" Target="../media/image9.jpeg"/><Relationship Id="rId20" Type="http://schemas.microsoft.com/office/2007/relationships/hdphoto" Target="../media/hdphoto6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11" Type="http://schemas.openxmlformats.org/officeDocument/2006/relationships/image" Target="../media/image5.jpeg"/><Relationship Id="rId5" Type="http://schemas.microsoft.com/office/2007/relationships/hdphoto" Target="../media/hdphoto1.wdp"/><Relationship Id="rId15" Type="http://schemas.microsoft.com/office/2007/relationships/hdphoto" Target="../media/hdphoto4.wdp"/><Relationship Id="rId10" Type="http://schemas.openxmlformats.org/officeDocument/2006/relationships/image" Target="../media/image4.jpeg"/><Relationship Id="rId19" Type="http://schemas.openxmlformats.org/officeDocument/2006/relationships/image" Target="../media/image11.png"/><Relationship Id="rId4" Type="http://schemas.openxmlformats.org/officeDocument/2006/relationships/image" Target="../media/image1.png"/><Relationship Id="rId9" Type="http://schemas.microsoft.com/office/2007/relationships/hdphoto" Target="../media/hdphoto3.wdp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TextBox 1">
            <a:extLst>
              <a:ext uri="{FF2B5EF4-FFF2-40B4-BE49-F238E27FC236}">
                <a16:creationId xmlns:a16="http://schemas.microsoft.com/office/drawing/2014/main" id="{E45086A3-741A-3E64-296A-052E1801EED8}"/>
              </a:ext>
            </a:extLst>
          </p:cNvPr>
          <p:cNvSpPr txBox="1"/>
          <p:nvPr/>
        </p:nvSpPr>
        <p:spPr>
          <a:xfrm>
            <a:off x="5663113" y="5099929"/>
            <a:ext cx="5201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U251</a:t>
            </a:r>
          </a:p>
        </p:txBody>
      </p:sp>
      <p:sp>
        <p:nvSpPr>
          <p:cNvPr id="156" name="TextBox 1">
            <a:extLst>
              <a:ext uri="{FF2B5EF4-FFF2-40B4-BE49-F238E27FC236}">
                <a16:creationId xmlns:a16="http://schemas.microsoft.com/office/drawing/2014/main" id="{5D0FB359-0E17-C557-E76E-778A80CD9109}"/>
              </a:ext>
            </a:extLst>
          </p:cNvPr>
          <p:cNvSpPr txBox="1"/>
          <p:nvPr/>
        </p:nvSpPr>
        <p:spPr>
          <a:xfrm>
            <a:off x="8830707" y="5104574"/>
            <a:ext cx="5201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U343</a:t>
            </a:r>
          </a:p>
        </p:txBody>
      </p:sp>
      <p:graphicFrame>
        <p:nvGraphicFramePr>
          <p:cNvPr id="157" name="Chart 156">
            <a:extLst>
              <a:ext uri="{FF2B5EF4-FFF2-40B4-BE49-F238E27FC236}">
                <a16:creationId xmlns:a16="http://schemas.microsoft.com/office/drawing/2014/main" id="{62AEF613-0BEC-47FA-A456-67FB7BE186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4678503"/>
              </p:ext>
            </p:extLst>
          </p:nvPr>
        </p:nvGraphicFramePr>
        <p:xfrm>
          <a:off x="3976347" y="5700480"/>
          <a:ext cx="3100466" cy="490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8" name="Chart 157">
            <a:extLst>
              <a:ext uri="{FF2B5EF4-FFF2-40B4-BE49-F238E27FC236}">
                <a16:creationId xmlns:a16="http://schemas.microsoft.com/office/drawing/2014/main" id="{11545D9B-2973-4F00-84DA-78DBA9B7A0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9637048"/>
              </p:ext>
            </p:extLst>
          </p:nvPr>
        </p:nvGraphicFramePr>
        <p:xfrm>
          <a:off x="7147367" y="5698419"/>
          <a:ext cx="3100466" cy="490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9" name="Freeform: Shape 158">
            <a:extLst>
              <a:ext uri="{FF2B5EF4-FFF2-40B4-BE49-F238E27FC236}">
                <a16:creationId xmlns:a16="http://schemas.microsoft.com/office/drawing/2014/main" id="{C3B5AC3F-8739-FC04-D7D7-B12904BF0361}"/>
              </a:ext>
            </a:extLst>
          </p:cNvPr>
          <p:cNvSpPr/>
          <p:nvPr/>
        </p:nvSpPr>
        <p:spPr>
          <a:xfrm rot="5400000">
            <a:off x="5415520" y="5658058"/>
            <a:ext cx="66583" cy="489600"/>
          </a:xfrm>
          <a:custGeom>
            <a:avLst/>
            <a:gdLst>
              <a:gd name="connsiteX0" fmla="*/ 426715 w 514345"/>
              <a:gd name="connsiteY0" fmla="*/ 0 h 1177290"/>
              <a:gd name="connsiteX1" fmla="*/ 20950 w 514345"/>
              <a:gd name="connsiteY1" fmla="*/ 462915 h 1177290"/>
              <a:gd name="connsiteX2" fmla="*/ 20950 w 514345"/>
              <a:gd name="connsiteY2" fmla="*/ 462915 h 1177290"/>
              <a:gd name="connsiteX3" fmla="*/ 41905 w 514345"/>
              <a:gd name="connsiteY3" fmla="*/ 1042035 h 1177290"/>
              <a:gd name="connsiteX4" fmla="*/ 514345 w 514345"/>
              <a:gd name="connsiteY4" fmla="*/ 1177290 h 1177290"/>
              <a:gd name="connsiteX0" fmla="*/ 466725 w 554355"/>
              <a:gd name="connsiteY0" fmla="*/ 0 h 1177290"/>
              <a:gd name="connsiteX1" fmla="*/ 60960 w 554355"/>
              <a:gd name="connsiteY1" fmla="*/ 462915 h 1177290"/>
              <a:gd name="connsiteX2" fmla="*/ 0 w 554355"/>
              <a:gd name="connsiteY2" fmla="*/ 224790 h 1177290"/>
              <a:gd name="connsiteX3" fmla="*/ 81915 w 554355"/>
              <a:gd name="connsiteY3" fmla="*/ 1042035 h 1177290"/>
              <a:gd name="connsiteX4" fmla="*/ 554355 w 554355"/>
              <a:gd name="connsiteY4" fmla="*/ 1177290 h 1177290"/>
              <a:gd name="connsiteX0" fmla="*/ 466725 w 554355"/>
              <a:gd name="connsiteY0" fmla="*/ 0 h 1177290"/>
              <a:gd name="connsiteX1" fmla="*/ 161925 w 554355"/>
              <a:gd name="connsiteY1" fmla="*/ 123825 h 1177290"/>
              <a:gd name="connsiteX2" fmla="*/ 0 w 554355"/>
              <a:gd name="connsiteY2" fmla="*/ 224790 h 1177290"/>
              <a:gd name="connsiteX3" fmla="*/ 81915 w 554355"/>
              <a:gd name="connsiteY3" fmla="*/ 1042035 h 1177290"/>
              <a:gd name="connsiteX4" fmla="*/ 554355 w 554355"/>
              <a:gd name="connsiteY4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389107 w 476737"/>
              <a:gd name="connsiteY0" fmla="*/ 0 h 1177290"/>
              <a:gd name="connsiteX1" fmla="*/ 225277 w 476737"/>
              <a:gd name="connsiteY1" fmla="*/ 20955 h 1177290"/>
              <a:gd name="connsiteX2" fmla="*/ 4297 w 476737"/>
              <a:gd name="connsiteY2" fmla="*/ 1042035 h 1177290"/>
              <a:gd name="connsiteX3" fmla="*/ 476737 w 476737"/>
              <a:gd name="connsiteY3" fmla="*/ 1177290 h 1177290"/>
              <a:gd name="connsiteX0" fmla="*/ 392917 w 476737"/>
              <a:gd name="connsiteY0" fmla="*/ 0 h 1160145"/>
              <a:gd name="connsiteX1" fmla="*/ 225277 w 476737"/>
              <a:gd name="connsiteY1" fmla="*/ 3810 h 1160145"/>
              <a:gd name="connsiteX2" fmla="*/ 4297 w 476737"/>
              <a:gd name="connsiteY2" fmla="*/ 1024890 h 1160145"/>
              <a:gd name="connsiteX3" fmla="*/ 476737 w 476737"/>
              <a:gd name="connsiteY3" fmla="*/ 1160145 h 1160145"/>
              <a:gd name="connsiteX0" fmla="*/ 392121 w 475941"/>
              <a:gd name="connsiteY0" fmla="*/ 1905 h 1162050"/>
              <a:gd name="connsiteX1" fmla="*/ 291156 w 475941"/>
              <a:gd name="connsiteY1" fmla="*/ 0 h 1162050"/>
              <a:gd name="connsiteX2" fmla="*/ 3501 w 475941"/>
              <a:gd name="connsiteY2" fmla="*/ 1026795 h 1162050"/>
              <a:gd name="connsiteX3" fmla="*/ 475941 w 475941"/>
              <a:gd name="connsiteY3" fmla="*/ 1162050 h 1162050"/>
              <a:gd name="connsiteX0" fmla="*/ 111533 w 195353"/>
              <a:gd name="connsiteY0" fmla="*/ 1905 h 1162050"/>
              <a:gd name="connsiteX1" fmla="*/ 10568 w 195353"/>
              <a:gd name="connsiteY1" fmla="*/ 0 h 1162050"/>
              <a:gd name="connsiteX2" fmla="*/ 20093 w 195353"/>
              <a:gd name="connsiteY2" fmla="*/ 1003935 h 1162050"/>
              <a:gd name="connsiteX3" fmla="*/ 195353 w 195353"/>
              <a:gd name="connsiteY3" fmla="*/ 1162050 h 1162050"/>
              <a:gd name="connsiteX0" fmla="*/ 111533 w 117248"/>
              <a:gd name="connsiteY0" fmla="*/ 1905 h 1060218"/>
              <a:gd name="connsiteX1" fmla="*/ 10568 w 117248"/>
              <a:gd name="connsiteY1" fmla="*/ 0 h 1060218"/>
              <a:gd name="connsiteX2" fmla="*/ 20093 w 117248"/>
              <a:gd name="connsiteY2" fmla="*/ 1003935 h 1060218"/>
              <a:gd name="connsiteX3" fmla="*/ 117248 w 117248"/>
              <a:gd name="connsiteY3" fmla="*/ 1022985 h 1060218"/>
              <a:gd name="connsiteX0" fmla="*/ 111533 w 117248"/>
              <a:gd name="connsiteY0" fmla="*/ 1905 h 1062161"/>
              <a:gd name="connsiteX1" fmla="*/ 10568 w 117248"/>
              <a:gd name="connsiteY1" fmla="*/ 0 h 1062161"/>
              <a:gd name="connsiteX2" fmla="*/ 20093 w 117248"/>
              <a:gd name="connsiteY2" fmla="*/ 1003935 h 1062161"/>
              <a:gd name="connsiteX3" fmla="*/ 117248 w 117248"/>
              <a:gd name="connsiteY3" fmla="*/ 1022985 h 1062161"/>
              <a:gd name="connsiteX0" fmla="*/ 111533 w 117248"/>
              <a:gd name="connsiteY0" fmla="*/ 1905 h 1062161"/>
              <a:gd name="connsiteX1" fmla="*/ 10568 w 117248"/>
              <a:gd name="connsiteY1" fmla="*/ 0 h 1062161"/>
              <a:gd name="connsiteX2" fmla="*/ 20093 w 117248"/>
              <a:gd name="connsiteY2" fmla="*/ 1003935 h 1062161"/>
              <a:gd name="connsiteX3" fmla="*/ 117248 w 117248"/>
              <a:gd name="connsiteY3" fmla="*/ 1022985 h 1062161"/>
              <a:gd name="connsiteX0" fmla="*/ 111533 w 117248"/>
              <a:gd name="connsiteY0" fmla="*/ 1905 h 1022985"/>
              <a:gd name="connsiteX1" fmla="*/ 10568 w 117248"/>
              <a:gd name="connsiteY1" fmla="*/ 0 h 1022985"/>
              <a:gd name="connsiteX2" fmla="*/ 20093 w 117248"/>
              <a:gd name="connsiteY2" fmla="*/ 1003935 h 1022985"/>
              <a:gd name="connsiteX3" fmla="*/ 117248 w 117248"/>
              <a:gd name="connsiteY3" fmla="*/ 1022985 h 1022985"/>
              <a:gd name="connsiteX0" fmla="*/ 111533 w 117248"/>
              <a:gd name="connsiteY0" fmla="*/ 1905 h 1025061"/>
              <a:gd name="connsiteX1" fmla="*/ 10568 w 117248"/>
              <a:gd name="connsiteY1" fmla="*/ 0 h 1025061"/>
              <a:gd name="connsiteX2" fmla="*/ 20093 w 117248"/>
              <a:gd name="connsiteY2" fmla="*/ 1024890 h 1025061"/>
              <a:gd name="connsiteX3" fmla="*/ 117248 w 117248"/>
              <a:gd name="connsiteY3" fmla="*/ 1022985 h 1025061"/>
              <a:gd name="connsiteX0" fmla="*/ 111533 w 117248"/>
              <a:gd name="connsiteY0" fmla="*/ 1905 h 1023320"/>
              <a:gd name="connsiteX1" fmla="*/ 10568 w 117248"/>
              <a:gd name="connsiteY1" fmla="*/ 0 h 1023320"/>
              <a:gd name="connsiteX2" fmla="*/ 20093 w 117248"/>
              <a:gd name="connsiteY2" fmla="*/ 1022985 h 1023320"/>
              <a:gd name="connsiteX3" fmla="*/ 117248 w 117248"/>
              <a:gd name="connsiteY3" fmla="*/ 1022985 h 1023320"/>
              <a:gd name="connsiteX0" fmla="*/ 100965 w 106680"/>
              <a:gd name="connsiteY0" fmla="*/ 1905 h 1023320"/>
              <a:gd name="connsiteX1" fmla="*/ 0 w 106680"/>
              <a:gd name="connsiteY1" fmla="*/ 0 h 1023320"/>
              <a:gd name="connsiteX2" fmla="*/ 9525 w 106680"/>
              <a:gd name="connsiteY2" fmla="*/ 1022985 h 1023320"/>
              <a:gd name="connsiteX3" fmla="*/ 106680 w 106680"/>
              <a:gd name="connsiteY3" fmla="*/ 1022985 h 1023320"/>
              <a:gd name="connsiteX0" fmla="*/ 100965 w 106680"/>
              <a:gd name="connsiteY0" fmla="*/ 0 h 1021415"/>
              <a:gd name="connsiteX1" fmla="*/ 0 w 106680"/>
              <a:gd name="connsiteY1" fmla="*/ 3810 h 1021415"/>
              <a:gd name="connsiteX2" fmla="*/ 9525 w 106680"/>
              <a:gd name="connsiteY2" fmla="*/ 1021080 h 1021415"/>
              <a:gd name="connsiteX3" fmla="*/ 106680 w 106680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74 w 104789"/>
              <a:gd name="connsiteY0" fmla="*/ 0 h 1021415"/>
              <a:gd name="connsiteX1" fmla="*/ 14 w 104789"/>
              <a:gd name="connsiteY1" fmla="*/ 3810 h 1021415"/>
              <a:gd name="connsiteX2" fmla="*/ 7634 w 104789"/>
              <a:gd name="connsiteY2" fmla="*/ 1021080 h 1021415"/>
              <a:gd name="connsiteX3" fmla="*/ 104789 w 104789"/>
              <a:gd name="connsiteY3" fmla="*/ 1021080 h 1021415"/>
              <a:gd name="connsiteX0" fmla="*/ 9529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9529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93393 w 101013"/>
              <a:gd name="connsiteY0" fmla="*/ 0 h 1019510"/>
              <a:gd name="connsiteX1" fmla="*/ 48 w 101013"/>
              <a:gd name="connsiteY1" fmla="*/ 3810 h 1019510"/>
              <a:gd name="connsiteX2" fmla="*/ 3858 w 101013"/>
              <a:gd name="connsiteY2" fmla="*/ 1019175 h 1019510"/>
              <a:gd name="connsiteX3" fmla="*/ 101013 w 101013"/>
              <a:gd name="connsiteY3" fmla="*/ 1019175 h 1019510"/>
              <a:gd name="connsiteX0" fmla="*/ 5338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102918 w 102918"/>
              <a:gd name="connsiteY0" fmla="*/ 2300 h 1016095"/>
              <a:gd name="connsiteX1" fmla="*/ 48 w 102918"/>
              <a:gd name="connsiteY1" fmla="*/ 395 h 1016095"/>
              <a:gd name="connsiteX2" fmla="*/ 3858 w 102918"/>
              <a:gd name="connsiteY2" fmla="*/ 1015760 h 1016095"/>
              <a:gd name="connsiteX3" fmla="*/ 101013 w 102918"/>
              <a:gd name="connsiteY3" fmla="*/ 1015760 h 1016095"/>
              <a:gd name="connsiteX0" fmla="*/ 102918 w 102918"/>
              <a:gd name="connsiteY0" fmla="*/ 0 h 1017605"/>
              <a:gd name="connsiteX1" fmla="*/ 48 w 102918"/>
              <a:gd name="connsiteY1" fmla="*/ 1905 h 1017605"/>
              <a:gd name="connsiteX2" fmla="*/ 3858 w 102918"/>
              <a:gd name="connsiteY2" fmla="*/ 1017270 h 1017605"/>
              <a:gd name="connsiteX3" fmla="*/ 101013 w 102918"/>
              <a:gd name="connsiteY3" fmla="*/ 1017270 h 10176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918" h="1017605">
                <a:moveTo>
                  <a:pt x="102918" y="0"/>
                </a:moveTo>
                <a:cubicBezTo>
                  <a:pt x="71168" y="1905"/>
                  <a:pt x="54658" y="0"/>
                  <a:pt x="48" y="1905"/>
                </a:cubicBezTo>
                <a:cubicBezTo>
                  <a:pt x="-270" y="113665"/>
                  <a:pt x="1000" y="846772"/>
                  <a:pt x="3858" y="1017270"/>
                </a:cubicBezTo>
                <a:cubicBezTo>
                  <a:pt x="61325" y="1018222"/>
                  <a:pt x="46879" y="1016793"/>
                  <a:pt x="101013" y="101727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60" name="Freeform: Shape 159">
            <a:extLst>
              <a:ext uri="{FF2B5EF4-FFF2-40B4-BE49-F238E27FC236}">
                <a16:creationId xmlns:a16="http://schemas.microsoft.com/office/drawing/2014/main" id="{08324CCA-6430-4712-4082-7469E148B2DA}"/>
              </a:ext>
            </a:extLst>
          </p:cNvPr>
          <p:cNvSpPr/>
          <p:nvPr/>
        </p:nvSpPr>
        <p:spPr>
          <a:xfrm rot="5400000">
            <a:off x="5660321" y="5125789"/>
            <a:ext cx="66583" cy="979200"/>
          </a:xfrm>
          <a:custGeom>
            <a:avLst/>
            <a:gdLst>
              <a:gd name="connsiteX0" fmla="*/ 426715 w 514345"/>
              <a:gd name="connsiteY0" fmla="*/ 0 h 1177290"/>
              <a:gd name="connsiteX1" fmla="*/ 20950 w 514345"/>
              <a:gd name="connsiteY1" fmla="*/ 462915 h 1177290"/>
              <a:gd name="connsiteX2" fmla="*/ 20950 w 514345"/>
              <a:gd name="connsiteY2" fmla="*/ 462915 h 1177290"/>
              <a:gd name="connsiteX3" fmla="*/ 41905 w 514345"/>
              <a:gd name="connsiteY3" fmla="*/ 1042035 h 1177290"/>
              <a:gd name="connsiteX4" fmla="*/ 514345 w 514345"/>
              <a:gd name="connsiteY4" fmla="*/ 1177290 h 1177290"/>
              <a:gd name="connsiteX0" fmla="*/ 466725 w 554355"/>
              <a:gd name="connsiteY0" fmla="*/ 0 h 1177290"/>
              <a:gd name="connsiteX1" fmla="*/ 60960 w 554355"/>
              <a:gd name="connsiteY1" fmla="*/ 462915 h 1177290"/>
              <a:gd name="connsiteX2" fmla="*/ 0 w 554355"/>
              <a:gd name="connsiteY2" fmla="*/ 224790 h 1177290"/>
              <a:gd name="connsiteX3" fmla="*/ 81915 w 554355"/>
              <a:gd name="connsiteY3" fmla="*/ 1042035 h 1177290"/>
              <a:gd name="connsiteX4" fmla="*/ 554355 w 554355"/>
              <a:gd name="connsiteY4" fmla="*/ 1177290 h 1177290"/>
              <a:gd name="connsiteX0" fmla="*/ 466725 w 554355"/>
              <a:gd name="connsiteY0" fmla="*/ 0 h 1177290"/>
              <a:gd name="connsiteX1" fmla="*/ 161925 w 554355"/>
              <a:gd name="connsiteY1" fmla="*/ 123825 h 1177290"/>
              <a:gd name="connsiteX2" fmla="*/ 0 w 554355"/>
              <a:gd name="connsiteY2" fmla="*/ 224790 h 1177290"/>
              <a:gd name="connsiteX3" fmla="*/ 81915 w 554355"/>
              <a:gd name="connsiteY3" fmla="*/ 1042035 h 1177290"/>
              <a:gd name="connsiteX4" fmla="*/ 554355 w 554355"/>
              <a:gd name="connsiteY4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389107 w 476737"/>
              <a:gd name="connsiteY0" fmla="*/ 0 h 1177290"/>
              <a:gd name="connsiteX1" fmla="*/ 225277 w 476737"/>
              <a:gd name="connsiteY1" fmla="*/ 20955 h 1177290"/>
              <a:gd name="connsiteX2" fmla="*/ 4297 w 476737"/>
              <a:gd name="connsiteY2" fmla="*/ 1042035 h 1177290"/>
              <a:gd name="connsiteX3" fmla="*/ 476737 w 476737"/>
              <a:gd name="connsiteY3" fmla="*/ 1177290 h 1177290"/>
              <a:gd name="connsiteX0" fmla="*/ 392917 w 476737"/>
              <a:gd name="connsiteY0" fmla="*/ 0 h 1160145"/>
              <a:gd name="connsiteX1" fmla="*/ 225277 w 476737"/>
              <a:gd name="connsiteY1" fmla="*/ 3810 h 1160145"/>
              <a:gd name="connsiteX2" fmla="*/ 4297 w 476737"/>
              <a:gd name="connsiteY2" fmla="*/ 1024890 h 1160145"/>
              <a:gd name="connsiteX3" fmla="*/ 476737 w 476737"/>
              <a:gd name="connsiteY3" fmla="*/ 1160145 h 1160145"/>
              <a:gd name="connsiteX0" fmla="*/ 392121 w 475941"/>
              <a:gd name="connsiteY0" fmla="*/ 1905 h 1162050"/>
              <a:gd name="connsiteX1" fmla="*/ 291156 w 475941"/>
              <a:gd name="connsiteY1" fmla="*/ 0 h 1162050"/>
              <a:gd name="connsiteX2" fmla="*/ 3501 w 475941"/>
              <a:gd name="connsiteY2" fmla="*/ 1026795 h 1162050"/>
              <a:gd name="connsiteX3" fmla="*/ 475941 w 475941"/>
              <a:gd name="connsiteY3" fmla="*/ 1162050 h 1162050"/>
              <a:gd name="connsiteX0" fmla="*/ 111533 w 195353"/>
              <a:gd name="connsiteY0" fmla="*/ 1905 h 1162050"/>
              <a:gd name="connsiteX1" fmla="*/ 10568 w 195353"/>
              <a:gd name="connsiteY1" fmla="*/ 0 h 1162050"/>
              <a:gd name="connsiteX2" fmla="*/ 20093 w 195353"/>
              <a:gd name="connsiteY2" fmla="*/ 1003935 h 1162050"/>
              <a:gd name="connsiteX3" fmla="*/ 195353 w 195353"/>
              <a:gd name="connsiteY3" fmla="*/ 1162050 h 1162050"/>
              <a:gd name="connsiteX0" fmla="*/ 111533 w 117248"/>
              <a:gd name="connsiteY0" fmla="*/ 1905 h 1060218"/>
              <a:gd name="connsiteX1" fmla="*/ 10568 w 117248"/>
              <a:gd name="connsiteY1" fmla="*/ 0 h 1060218"/>
              <a:gd name="connsiteX2" fmla="*/ 20093 w 117248"/>
              <a:gd name="connsiteY2" fmla="*/ 1003935 h 1060218"/>
              <a:gd name="connsiteX3" fmla="*/ 117248 w 117248"/>
              <a:gd name="connsiteY3" fmla="*/ 1022985 h 1060218"/>
              <a:gd name="connsiteX0" fmla="*/ 111533 w 117248"/>
              <a:gd name="connsiteY0" fmla="*/ 1905 h 1062161"/>
              <a:gd name="connsiteX1" fmla="*/ 10568 w 117248"/>
              <a:gd name="connsiteY1" fmla="*/ 0 h 1062161"/>
              <a:gd name="connsiteX2" fmla="*/ 20093 w 117248"/>
              <a:gd name="connsiteY2" fmla="*/ 1003935 h 1062161"/>
              <a:gd name="connsiteX3" fmla="*/ 117248 w 117248"/>
              <a:gd name="connsiteY3" fmla="*/ 1022985 h 1062161"/>
              <a:gd name="connsiteX0" fmla="*/ 111533 w 117248"/>
              <a:gd name="connsiteY0" fmla="*/ 1905 h 1062161"/>
              <a:gd name="connsiteX1" fmla="*/ 10568 w 117248"/>
              <a:gd name="connsiteY1" fmla="*/ 0 h 1062161"/>
              <a:gd name="connsiteX2" fmla="*/ 20093 w 117248"/>
              <a:gd name="connsiteY2" fmla="*/ 1003935 h 1062161"/>
              <a:gd name="connsiteX3" fmla="*/ 117248 w 117248"/>
              <a:gd name="connsiteY3" fmla="*/ 1022985 h 1062161"/>
              <a:gd name="connsiteX0" fmla="*/ 111533 w 117248"/>
              <a:gd name="connsiteY0" fmla="*/ 1905 h 1022985"/>
              <a:gd name="connsiteX1" fmla="*/ 10568 w 117248"/>
              <a:gd name="connsiteY1" fmla="*/ 0 h 1022985"/>
              <a:gd name="connsiteX2" fmla="*/ 20093 w 117248"/>
              <a:gd name="connsiteY2" fmla="*/ 1003935 h 1022985"/>
              <a:gd name="connsiteX3" fmla="*/ 117248 w 117248"/>
              <a:gd name="connsiteY3" fmla="*/ 1022985 h 1022985"/>
              <a:gd name="connsiteX0" fmla="*/ 111533 w 117248"/>
              <a:gd name="connsiteY0" fmla="*/ 1905 h 1025061"/>
              <a:gd name="connsiteX1" fmla="*/ 10568 w 117248"/>
              <a:gd name="connsiteY1" fmla="*/ 0 h 1025061"/>
              <a:gd name="connsiteX2" fmla="*/ 20093 w 117248"/>
              <a:gd name="connsiteY2" fmla="*/ 1024890 h 1025061"/>
              <a:gd name="connsiteX3" fmla="*/ 117248 w 117248"/>
              <a:gd name="connsiteY3" fmla="*/ 1022985 h 1025061"/>
              <a:gd name="connsiteX0" fmla="*/ 111533 w 117248"/>
              <a:gd name="connsiteY0" fmla="*/ 1905 h 1023320"/>
              <a:gd name="connsiteX1" fmla="*/ 10568 w 117248"/>
              <a:gd name="connsiteY1" fmla="*/ 0 h 1023320"/>
              <a:gd name="connsiteX2" fmla="*/ 20093 w 117248"/>
              <a:gd name="connsiteY2" fmla="*/ 1022985 h 1023320"/>
              <a:gd name="connsiteX3" fmla="*/ 117248 w 117248"/>
              <a:gd name="connsiteY3" fmla="*/ 1022985 h 1023320"/>
              <a:gd name="connsiteX0" fmla="*/ 100965 w 106680"/>
              <a:gd name="connsiteY0" fmla="*/ 1905 h 1023320"/>
              <a:gd name="connsiteX1" fmla="*/ 0 w 106680"/>
              <a:gd name="connsiteY1" fmla="*/ 0 h 1023320"/>
              <a:gd name="connsiteX2" fmla="*/ 9525 w 106680"/>
              <a:gd name="connsiteY2" fmla="*/ 1022985 h 1023320"/>
              <a:gd name="connsiteX3" fmla="*/ 106680 w 106680"/>
              <a:gd name="connsiteY3" fmla="*/ 1022985 h 1023320"/>
              <a:gd name="connsiteX0" fmla="*/ 100965 w 106680"/>
              <a:gd name="connsiteY0" fmla="*/ 0 h 1021415"/>
              <a:gd name="connsiteX1" fmla="*/ 0 w 106680"/>
              <a:gd name="connsiteY1" fmla="*/ 3810 h 1021415"/>
              <a:gd name="connsiteX2" fmla="*/ 9525 w 106680"/>
              <a:gd name="connsiteY2" fmla="*/ 1021080 h 1021415"/>
              <a:gd name="connsiteX3" fmla="*/ 106680 w 106680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74 w 104789"/>
              <a:gd name="connsiteY0" fmla="*/ 0 h 1021415"/>
              <a:gd name="connsiteX1" fmla="*/ 14 w 104789"/>
              <a:gd name="connsiteY1" fmla="*/ 3810 h 1021415"/>
              <a:gd name="connsiteX2" fmla="*/ 7634 w 104789"/>
              <a:gd name="connsiteY2" fmla="*/ 1021080 h 1021415"/>
              <a:gd name="connsiteX3" fmla="*/ 104789 w 104789"/>
              <a:gd name="connsiteY3" fmla="*/ 1021080 h 1021415"/>
              <a:gd name="connsiteX0" fmla="*/ 9529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9529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93393 w 101013"/>
              <a:gd name="connsiteY0" fmla="*/ 0 h 1019510"/>
              <a:gd name="connsiteX1" fmla="*/ 48 w 101013"/>
              <a:gd name="connsiteY1" fmla="*/ 3810 h 1019510"/>
              <a:gd name="connsiteX2" fmla="*/ 3858 w 101013"/>
              <a:gd name="connsiteY2" fmla="*/ 1019175 h 1019510"/>
              <a:gd name="connsiteX3" fmla="*/ 101013 w 101013"/>
              <a:gd name="connsiteY3" fmla="*/ 1019175 h 1019510"/>
              <a:gd name="connsiteX0" fmla="*/ 5338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102918 w 102918"/>
              <a:gd name="connsiteY0" fmla="*/ 2300 h 1016095"/>
              <a:gd name="connsiteX1" fmla="*/ 48 w 102918"/>
              <a:gd name="connsiteY1" fmla="*/ 395 h 1016095"/>
              <a:gd name="connsiteX2" fmla="*/ 3858 w 102918"/>
              <a:gd name="connsiteY2" fmla="*/ 1015760 h 1016095"/>
              <a:gd name="connsiteX3" fmla="*/ 101013 w 102918"/>
              <a:gd name="connsiteY3" fmla="*/ 1015760 h 1016095"/>
              <a:gd name="connsiteX0" fmla="*/ 102918 w 102918"/>
              <a:gd name="connsiteY0" fmla="*/ 0 h 1017605"/>
              <a:gd name="connsiteX1" fmla="*/ 48 w 102918"/>
              <a:gd name="connsiteY1" fmla="*/ 1905 h 1017605"/>
              <a:gd name="connsiteX2" fmla="*/ 3858 w 102918"/>
              <a:gd name="connsiteY2" fmla="*/ 1017270 h 1017605"/>
              <a:gd name="connsiteX3" fmla="*/ 101013 w 102918"/>
              <a:gd name="connsiteY3" fmla="*/ 1017270 h 10176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918" h="1017605">
                <a:moveTo>
                  <a:pt x="102918" y="0"/>
                </a:moveTo>
                <a:cubicBezTo>
                  <a:pt x="71168" y="1905"/>
                  <a:pt x="54658" y="0"/>
                  <a:pt x="48" y="1905"/>
                </a:cubicBezTo>
                <a:cubicBezTo>
                  <a:pt x="-270" y="113665"/>
                  <a:pt x="1000" y="846772"/>
                  <a:pt x="3858" y="1017270"/>
                </a:cubicBezTo>
                <a:cubicBezTo>
                  <a:pt x="61325" y="1018222"/>
                  <a:pt x="46879" y="1016793"/>
                  <a:pt x="101013" y="101727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61" name="TextBox 1">
            <a:extLst>
              <a:ext uri="{FF2B5EF4-FFF2-40B4-BE49-F238E27FC236}">
                <a16:creationId xmlns:a16="http://schemas.microsoft.com/office/drawing/2014/main" id="{48476CBA-BF2C-548B-B07D-573CA58EB543}"/>
              </a:ext>
            </a:extLst>
          </p:cNvPr>
          <p:cNvSpPr txBox="1"/>
          <p:nvPr/>
        </p:nvSpPr>
        <p:spPr>
          <a:xfrm rot="16200000">
            <a:off x="6287457" y="7772584"/>
            <a:ext cx="78737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I &lt; 0.9</a:t>
            </a:r>
          </a:p>
        </p:txBody>
      </p:sp>
      <p:sp>
        <p:nvSpPr>
          <p:cNvPr id="162" name="Textfeld 2">
            <a:extLst>
              <a:ext uri="{FF2B5EF4-FFF2-40B4-BE49-F238E27FC236}">
                <a16:creationId xmlns:a16="http://schemas.microsoft.com/office/drawing/2014/main" id="{470080F8-7F7C-FA04-F13F-2E35F625C8E3}"/>
              </a:ext>
            </a:extLst>
          </p:cNvPr>
          <p:cNvSpPr txBox="1"/>
          <p:nvPr/>
        </p:nvSpPr>
        <p:spPr>
          <a:xfrm>
            <a:off x="5100440" y="5661433"/>
            <a:ext cx="70920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163" name="Textfeld 2">
            <a:extLst>
              <a:ext uri="{FF2B5EF4-FFF2-40B4-BE49-F238E27FC236}">
                <a16:creationId xmlns:a16="http://schemas.microsoft.com/office/drawing/2014/main" id="{DC834135-938C-8AAF-4598-5E027605D545}"/>
              </a:ext>
            </a:extLst>
          </p:cNvPr>
          <p:cNvSpPr txBox="1"/>
          <p:nvPr/>
        </p:nvSpPr>
        <p:spPr>
          <a:xfrm>
            <a:off x="5339012" y="5370456"/>
            <a:ext cx="70920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</a:p>
        </p:txBody>
      </p:sp>
      <p:sp>
        <p:nvSpPr>
          <p:cNvPr id="164" name="Freeform: Shape 163">
            <a:extLst>
              <a:ext uri="{FF2B5EF4-FFF2-40B4-BE49-F238E27FC236}">
                <a16:creationId xmlns:a16="http://schemas.microsoft.com/office/drawing/2014/main" id="{E7F0D9F9-2F52-81A6-56E2-5C0D6DBAF28C}"/>
              </a:ext>
            </a:extLst>
          </p:cNvPr>
          <p:cNvSpPr/>
          <p:nvPr/>
        </p:nvSpPr>
        <p:spPr>
          <a:xfrm rot="5400000">
            <a:off x="8584719" y="5753752"/>
            <a:ext cx="66583" cy="489600"/>
          </a:xfrm>
          <a:custGeom>
            <a:avLst/>
            <a:gdLst>
              <a:gd name="connsiteX0" fmla="*/ 426715 w 514345"/>
              <a:gd name="connsiteY0" fmla="*/ 0 h 1177290"/>
              <a:gd name="connsiteX1" fmla="*/ 20950 w 514345"/>
              <a:gd name="connsiteY1" fmla="*/ 462915 h 1177290"/>
              <a:gd name="connsiteX2" fmla="*/ 20950 w 514345"/>
              <a:gd name="connsiteY2" fmla="*/ 462915 h 1177290"/>
              <a:gd name="connsiteX3" fmla="*/ 41905 w 514345"/>
              <a:gd name="connsiteY3" fmla="*/ 1042035 h 1177290"/>
              <a:gd name="connsiteX4" fmla="*/ 514345 w 514345"/>
              <a:gd name="connsiteY4" fmla="*/ 1177290 h 1177290"/>
              <a:gd name="connsiteX0" fmla="*/ 466725 w 554355"/>
              <a:gd name="connsiteY0" fmla="*/ 0 h 1177290"/>
              <a:gd name="connsiteX1" fmla="*/ 60960 w 554355"/>
              <a:gd name="connsiteY1" fmla="*/ 462915 h 1177290"/>
              <a:gd name="connsiteX2" fmla="*/ 0 w 554355"/>
              <a:gd name="connsiteY2" fmla="*/ 224790 h 1177290"/>
              <a:gd name="connsiteX3" fmla="*/ 81915 w 554355"/>
              <a:gd name="connsiteY3" fmla="*/ 1042035 h 1177290"/>
              <a:gd name="connsiteX4" fmla="*/ 554355 w 554355"/>
              <a:gd name="connsiteY4" fmla="*/ 1177290 h 1177290"/>
              <a:gd name="connsiteX0" fmla="*/ 466725 w 554355"/>
              <a:gd name="connsiteY0" fmla="*/ 0 h 1177290"/>
              <a:gd name="connsiteX1" fmla="*/ 161925 w 554355"/>
              <a:gd name="connsiteY1" fmla="*/ 123825 h 1177290"/>
              <a:gd name="connsiteX2" fmla="*/ 0 w 554355"/>
              <a:gd name="connsiteY2" fmla="*/ 224790 h 1177290"/>
              <a:gd name="connsiteX3" fmla="*/ 81915 w 554355"/>
              <a:gd name="connsiteY3" fmla="*/ 1042035 h 1177290"/>
              <a:gd name="connsiteX4" fmla="*/ 554355 w 554355"/>
              <a:gd name="connsiteY4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389107 w 476737"/>
              <a:gd name="connsiteY0" fmla="*/ 0 h 1177290"/>
              <a:gd name="connsiteX1" fmla="*/ 225277 w 476737"/>
              <a:gd name="connsiteY1" fmla="*/ 20955 h 1177290"/>
              <a:gd name="connsiteX2" fmla="*/ 4297 w 476737"/>
              <a:gd name="connsiteY2" fmla="*/ 1042035 h 1177290"/>
              <a:gd name="connsiteX3" fmla="*/ 476737 w 476737"/>
              <a:gd name="connsiteY3" fmla="*/ 1177290 h 1177290"/>
              <a:gd name="connsiteX0" fmla="*/ 392917 w 476737"/>
              <a:gd name="connsiteY0" fmla="*/ 0 h 1160145"/>
              <a:gd name="connsiteX1" fmla="*/ 225277 w 476737"/>
              <a:gd name="connsiteY1" fmla="*/ 3810 h 1160145"/>
              <a:gd name="connsiteX2" fmla="*/ 4297 w 476737"/>
              <a:gd name="connsiteY2" fmla="*/ 1024890 h 1160145"/>
              <a:gd name="connsiteX3" fmla="*/ 476737 w 476737"/>
              <a:gd name="connsiteY3" fmla="*/ 1160145 h 1160145"/>
              <a:gd name="connsiteX0" fmla="*/ 392121 w 475941"/>
              <a:gd name="connsiteY0" fmla="*/ 1905 h 1162050"/>
              <a:gd name="connsiteX1" fmla="*/ 291156 w 475941"/>
              <a:gd name="connsiteY1" fmla="*/ 0 h 1162050"/>
              <a:gd name="connsiteX2" fmla="*/ 3501 w 475941"/>
              <a:gd name="connsiteY2" fmla="*/ 1026795 h 1162050"/>
              <a:gd name="connsiteX3" fmla="*/ 475941 w 475941"/>
              <a:gd name="connsiteY3" fmla="*/ 1162050 h 1162050"/>
              <a:gd name="connsiteX0" fmla="*/ 111533 w 195353"/>
              <a:gd name="connsiteY0" fmla="*/ 1905 h 1162050"/>
              <a:gd name="connsiteX1" fmla="*/ 10568 w 195353"/>
              <a:gd name="connsiteY1" fmla="*/ 0 h 1162050"/>
              <a:gd name="connsiteX2" fmla="*/ 20093 w 195353"/>
              <a:gd name="connsiteY2" fmla="*/ 1003935 h 1162050"/>
              <a:gd name="connsiteX3" fmla="*/ 195353 w 195353"/>
              <a:gd name="connsiteY3" fmla="*/ 1162050 h 1162050"/>
              <a:gd name="connsiteX0" fmla="*/ 111533 w 117248"/>
              <a:gd name="connsiteY0" fmla="*/ 1905 h 1060218"/>
              <a:gd name="connsiteX1" fmla="*/ 10568 w 117248"/>
              <a:gd name="connsiteY1" fmla="*/ 0 h 1060218"/>
              <a:gd name="connsiteX2" fmla="*/ 20093 w 117248"/>
              <a:gd name="connsiteY2" fmla="*/ 1003935 h 1060218"/>
              <a:gd name="connsiteX3" fmla="*/ 117248 w 117248"/>
              <a:gd name="connsiteY3" fmla="*/ 1022985 h 1060218"/>
              <a:gd name="connsiteX0" fmla="*/ 111533 w 117248"/>
              <a:gd name="connsiteY0" fmla="*/ 1905 h 1062161"/>
              <a:gd name="connsiteX1" fmla="*/ 10568 w 117248"/>
              <a:gd name="connsiteY1" fmla="*/ 0 h 1062161"/>
              <a:gd name="connsiteX2" fmla="*/ 20093 w 117248"/>
              <a:gd name="connsiteY2" fmla="*/ 1003935 h 1062161"/>
              <a:gd name="connsiteX3" fmla="*/ 117248 w 117248"/>
              <a:gd name="connsiteY3" fmla="*/ 1022985 h 1062161"/>
              <a:gd name="connsiteX0" fmla="*/ 111533 w 117248"/>
              <a:gd name="connsiteY0" fmla="*/ 1905 h 1062161"/>
              <a:gd name="connsiteX1" fmla="*/ 10568 w 117248"/>
              <a:gd name="connsiteY1" fmla="*/ 0 h 1062161"/>
              <a:gd name="connsiteX2" fmla="*/ 20093 w 117248"/>
              <a:gd name="connsiteY2" fmla="*/ 1003935 h 1062161"/>
              <a:gd name="connsiteX3" fmla="*/ 117248 w 117248"/>
              <a:gd name="connsiteY3" fmla="*/ 1022985 h 1062161"/>
              <a:gd name="connsiteX0" fmla="*/ 111533 w 117248"/>
              <a:gd name="connsiteY0" fmla="*/ 1905 h 1022985"/>
              <a:gd name="connsiteX1" fmla="*/ 10568 w 117248"/>
              <a:gd name="connsiteY1" fmla="*/ 0 h 1022985"/>
              <a:gd name="connsiteX2" fmla="*/ 20093 w 117248"/>
              <a:gd name="connsiteY2" fmla="*/ 1003935 h 1022985"/>
              <a:gd name="connsiteX3" fmla="*/ 117248 w 117248"/>
              <a:gd name="connsiteY3" fmla="*/ 1022985 h 1022985"/>
              <a:gd name="connsiteX0" fmla="*/ 111533 w 117248"/>
              <a:gd name="connsiteY0" fmla="*/ 1905 h 1025061"/>
              <a:gd name="connsiteX1" fmla="*/ 10568 w 117248"/>
              <a:gd name="connsiteY1" fmla="*/ 0 h 1025061"/>
              <a:gd name="connsiteX2" fmla="*/ 20093 w 117248"/>
              <a:gd name="connsiteY2" fmla="*/ 1024890 h 1025061"/>
              <a:gd name="connsiteX3" fmla="*/ 117248 w 117248"/>
              <a:gd name="connsiteY3" fmla="*/ 1022985 h 1025061"/>
              <a:gd name="connsiteX0" fmla="*/ 111533 w 117248"/>
              <a:gd name="connsiteY0" fmla="*/ 1905 h 1023320"/>
              <a:gd name="connsiteX1" fmla="*/ 10568 w 117248"/>
              <a:gd name="connsiteY1" fmla="*/ 0 h 1023320"/>
              <a:gd name="connsiteX2" fmla="*/ 20093 w 117248"/>
              <a:gd name="connsiteY2" fmla="*/ 1022985 h 1023320"/>
              <a:gd name="connsiteX3" fmla="*/ 117248 w 117248"/>
              <a:gd name="connsiteY3" fmla="*/ 1022985 h 1023320"/>
              <a:gd name="connsiteX0" fmla="*/ 100965 w 106680"/>
              <a:gd name="connsiteY0" fmla="*/ 1905 h 1023320"/>
              <a:gd name="connsiteX1" fmla="*/ 0 w 106680"/>
              <a:gd name="connsiteY1" fmla="*/ 0 h 1023320"/>
              <a:gd name="connsiteX2" fmla="*/ 9525 w 106680"/>
              <a:gd name="connsiteY2" fmla="*/ 1022985 h 1023320"/>
              <a:gd name="connsiteX3" fmla="*/ 106680 w 106680"/>
              <a:gd name="connsiteY3" fmla="*/ 1022985 h 1023320"/>
              <a:gd name="connsiteX0" fmla="*/ 100965 w 106680"/>
              <a:gd name="connsiteY0" fmla="*/ 0 h 1021415"/>
              <a:gd name="connsiteX1" fmla="*/ 0 w 106680"/>
              <a:gd name="connsiteY1" fmla="*/ 3810 h 1021415"/>
              <a:gd name="connsiteX2" fmla="*/ 9525 w 106680"/>
              <a:gd name="connsiteY2" fmla="*/ 1021080 h 1021415"/>
              <a:gd name="connsiteX3" fmla="*/ 106680 w 106680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74 w 104789"/>
              <a:gd name="connsiteY0" fmla="*/ 0 h 1021415"/>
              <a:gd name="connsiteX1" fmla="*/ 14 w 104789"/>
              <a:gd name="connsiteY1" fmla="*/ 3810 h 1021415"/>
              <a:gd name="connsiteX2" fmla="*/ 7634 w 104789"/>
              <a:gd name="connsiteY2" fmla="*/ 1021080 h 1021415"/>
              <a:gd name="connsiteX3" fmla="*/ 104789 w 104789"/>
              <a:gd name="connsiteY3" fmla="*/ 1021080 h 1021415"/>
              <a:gd name="connsiteX0" fmla="*/ 9529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9529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93393 w 101013"/>
              <a:gd name="connsiteY0" fmla="*/ 0 h 1019510"/>
              <a:gd name="connsiteX1" fmla="*/ 48 w 101013"/>
              <a:gd name="connsiteY1" fmla="*/ 3810 h 1019510"/>
              <a:gd name="connsiteX2" fmla="*/ 3858 w 101013"/>
              <a:gd name="connsiteY2" fmla="*/ 1019175 h 1019510"/>
              <a:gd name="connsiteX3" fmla="*/ 101013 w 101013"/>
              <a:gd name="connsiteY3" fmla="*/ 1019175 h 1019510"/>
              <a:gd name="connsiteX0" fmla="*/ 5338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102918 w 102918"/>
              <a:gd name="connsiteY0" fmla="*/ 2300 h 1016095"/>
              <a:gd name="connsiteX1" fmla="*/ 48 w 102918"/>
              <a:gd name="connsiteY1" fmla="*/ 395 h 1016095"/>
              <a:gd name="connsiteX2" fmla="*/ 3858 w 102918"/>
              <a:gd name="connsiteY2" fmla="*/ 1015760 h 1016095"/>
              <a:gd name="connsiteX3" fmla="*/ 101013 w 102918"/>
              <a:gd name="connsiteY3" fmla="*/ 1015760 h 1016095"/>
              <a:gd name="connsiteX0" fmla="*/ 102918 w 102918"/>
              <a:gd name="connsiteY0" fmla="*/ 0 h 1017605"/>
              <a:gd name="connsiteX1" fmla="*/ 48 w 102918"/>
              <a:gd name="connsiteY1" fmla="*/ 1905 h 1017605"/>
              <a:gd name="connsiteX2" fmla="*/ 3858 w 102918"/>
              <a:gd name="connsiteY2" fmla="*/ 1017270 h 1017605"/>
              <a:gd name="connsiteX3" fmla="*/ 101013 w 102918"/>
              <a:gd name="connsiteY3" fmla="*/ 1017270 h 10176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918" h="1017605">
                <a:moveTo>
                  <a:pt x="102918" y="0"/>
                </a:moveTo>
                <a:cubicBezTo>
                  <a:pt x="71168" y="1905"/>
                  <a:pt x="54658" y="0"/>
                  <a:pt x="48" y="1905"/>
                </a:cubicBezTo>
                <a:cubicBezTo>
                  <a:pt x="-270" y="113665"/>
                  <a:pt x="1000" y="846772"/>
                  <a:pt x="3858" y="1017270"/>
                </a:cubicBezTo>
                <a:cubicBezTo>
                  <a:pt x="61325" y="1018222"/>
                  <a:pt x="46879" y="1016793"/>
                  <a:pt x="101013" y="101727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65" name="Freeform: Shape 164">
            <a:extLst>
              <a:ext uri="{FF2B5EF4-FFF2-40B4-BE49-F238E27FC236}">
                <a16:creationId xmlns:a16="http://schemas.microsoft.com/office/drawing/2014/main" id="{6CA5C662-0258-3622-D24A-22A1AEC7DC54}"/>
              </a:ext>
            </a:extLst>
          </p:cNvPr>
          <p:cNvSpPr/>
          <p:nvPr/>
        </p:nvSpPr>
        <p:spPr>
          <a:xfrm rot="5400000">
            <a:off x="8829520" y="5221483"/>
            <a:ext cx="66583" cy="979200"/>
          </a:xfrm>
          <a:custGeom>
            <a:avLst/>
            <a:gdLst>
              <a:gd name="connsiteX0" fmla="*/ 426715 w 514345"/>
              <a:gd name="connsiteY0" fmla="*/ 0 h 1177290"/>
              <a:gd name="connsiteX1" fmla="*/ 20950 w 514345"/>
              <a:gd name="connsiteY1" fmla="*/ 462915 h 1177290"/>
              <a:gd name="connsiteX2" fmla="*/ 20950 w 514345"/>
              <a:gd name="connsiteY2" fmla="*/ 462915 h 1177290"/>
              <a:gd name="connsiteX3" fmla="*/ 41905 w 514345"/>
              <a:gd name="connsiteY3" fmla="*/ 1042035 h 1177290"/>
              <a:gd name="connsiteX4" fmla="*/ 514345 w 514345"/>
              <a:gd name="connsiteY4" fmla="*/ 1177290 h 1177290"/>
              <a:gd name="connsiteX0" fmla="*/ 466725 w 554355"/>
              <a:gd name="connsiteY0" fmla="*/ 0 h 1177290"/>
              <a:gd name="connsiteX1" fmla="*/ 60960 w 554355"/>
              <a:gd name="connsiteY1" fmla="*/ 462915 h 1177290"/>
              <a:gd name="connsiteX2" fmla="*/ 0 w 554355"/>
              <a:gd name="connsiteY2" fmla="*/ 224790 h 1177290"/>
              <a:gd name="connsiteX3" fmla="*/ 81915 w 554355"/>
              <a:gd name="connsiteY3" fmla="*/ 1042035 h 1177290"/>
              <a:gd name="connsiteX4" fmla="*/ 554355 w 554355"/>
              <a:gd name="connsiteY4" fmla="*/ 1177290 h 1177290"/>
              <a:gd name="connsiteX0" fmla="*/ 466725 w 554355"/>
              <a:gd name="connsiteY0" fmla="*/ 0 h 1177290"/>
              <a:gd name="connsiteX1" fmla="*/ 161925 w 554355"/>
              <a:gd name="connsiteY1" fmla="*/ 123825 h 1177290"/>
              <a:gd name="connsiteX2" fmla="*/ 0 w 554355"/>
              <a:gd name="connsiteY2" fmla="*/ 224790 h 1177290"/>
              <a:gd name="connsiteX3" fmla="*/ 81915 w 554355"/>
              <a:gd name="connsiteY3" fmla="*/ 1042035 h 1177290"/>
              <a:gd name="connsiteX4" fmla="*/ 554355 w 554355"/>
              <a:gd name="connsiteY4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466725 w 554355"/>
              <a:gd name="connsiteY0" fmla="*/ 0 h 1177290"/>
              <a:gd name="connsiteX1" fmla="*/ 0 w 554355"/>
              <a:gd name="connsiteY1" fmla="*/ 224790 h 1177290"/>
              <a:gd name="connsiteX2" fmla="*/ 81915 w 554355"/>
              <a:gd name="connsiteY2" fmla="*/ 1042035 h 1177290"/>
              <a:gd name="connsiteX3" fmla="*/ 554355 w 554355"/>
              <a:gd name="connsiteY3" fmla="*/ 1177290 h 1177290"/>
              <a:gd name="connsiteX0" fmla="*/ 389107 w 476737"/>
              <a:gd name="connsiteY0" fmla="*/ 0 h 1177290"/>
              <a:gd name="connsiteX1" fmla="*/ 225277 w 476737"/>
              <a:gd name="connsiteY1" fmla="*/ 20955 h 1177290"/>
              <a:gd name="connsiteX2" fmla="*/ 4297 w 476737"/>
              <a:gd name="connsiteY2" fmla="*/ 1042035 h 1177290"/>
              <a:gd name="connsiteX3" fmla="*/ 476737 w 476737"/>
              <a:gd name="connsiteY3" fmla="*/ 1177290 h 1177290"/>
              <a:gd name="connsiteX0" fmla="*/ 392917 w 476737"/>
              <a:gd name="connsiteY0" fmla="*/ 0 h 1160145"/>
              <a:gd name="connsiteX1" fmla="*/ 225277 w 476737"/>
              <a:gd name="connsiteY1" fmla="*/ 3810 h 1160145"/>
              <a:gd name="connsiteX2" fmla="*/ 4297 w 476737"/>
              <a:gd name="connsiteY2" fmla="*/ 1024890 h 1160145"/>
              <a:gd name="connsiteX3" fmla="*/ 476737 w 476737"/>
              <a:gd name="connsiteY3" fmla="*/ 1160145 h 1160145"/>
              <a:gd name="connsiteX0" fmla="*/ 392121 w 475941"/>
              <a:gd name="connsiteY0" fmla="*/ 1905 h 1162050"/>
              <a:gd name="connsiteX1" fmla="*/ 291156 w 475941"/>
              <a:gd name="connsiteY1" fmla="*/ 0 h 1162050"/>
              <a:gd name="connsiteX2" fmla="*/ 3501 w 475941"/>
              <a:gd name="connsiteY2" fmla="*/ 1026795 h 1162050"/>
              <a:gd name="connsiteX3" fmla="*/ 475941 w 475941"/>
              <a:gd name="connsiteY3" fmla="*/ 1162050 h 1162050"/>
              <a:gd name="connsiteX0" fmla="*/ 111533 w 195353"/>
              <a:gd name="connsiteY0" fmla="*/ 1905 h 1162050"/>
              <a:gd name="connsiteX1" fmla="*/ 10568 w 195353"/>
              <a:gd name="connsiteY1" fmla="*/ 0 h 1162050"/>
              <a:gd name="connsiteX2" fmla="*/ 20093 w 195353"/>
              <a:gd name="connsiteY2" fmla="*/ 1003935 h 1162050"/>
              <a:gd name="connsiteX3" fmla="*/ 195353 w 195353"/>
              <a:gd name="connsiteY3" fmla="*/ 1162050 h 1162050"/>
              <a:gd name="connsiteX0" fmla="*/ 111533 w 117248"/>
              <a:gd name="connsiteY0" fmla="*/ 1905 h 1060218"/>
              <a:gd name="connsiteX1" fmla="*/ 10568 w 117248"/>
              <a:gd name="connsiteY1" fmla="*/ 0 h 1060218"/>
              <a:gd name="connsiteX2" fmla="*/ 20093 w 117248"/>
              <a:gd name="connsiteY2" fmla="*/ 1003935 h 1060218"/>
              <a:gd name="connsiteX3" fmla="*/ 117248 w 117248"/>
              <a:gd name="connsiteY3" fmla="*/ 1022985 h 1060218"/>
              <a:gd name="connsiteX0" fmla="*/ 111533 w 117248"/>
              <a:gd name="connsiteY0" fmla="*/ 1905 h 1062161"/>
              <a:gd name="connsiteX1" fmla="*/ 10568 w 117248"/>
              <a:gd name="connsiteY1" fmla="*/ 0 h 1062161"/>
              <a:gd name="connsiteX2" fmla="*/ 20093 w 117248"/>
              <a:gd name="connsiteY2" fmla="*/ 1003935 h 1062161"/>
              <a:gd name="connsiteX3" fmla="*/ 117248 w 117248"/>
              <a:gd name="connsiteY3" fmla="*/ 1022985 h 1062161"/>
              <a:gd name="connsiteX0" fmla="*/ 111533 w 117248"/>
              <a:gd name="connsiteY0" fmla="*/ 1905 h 1062161"/>
              <a:gd name="connsiteX1" fmla="*/ 10568 w 117248"/>
              <a:gd name="connsiteY1" fmla="*/ 0 h 1062161"/>
              <a:gd name="connsiteX2" fmla="*/ 20093 w 117248"/>
              <a:gd name="connsiteY2" fmla="*/ 1003935 h 1062161"/>
              <a:gd name="connsiteX3" fmla="*/ 117248 w 117248"/>
              <a:gd name="connsiteY3" fmla="*/ 1022985 h 1062161"/>
              <a:gd name="connsiteX0" fmla="*/ 111533 w 117248"/>
              <a:gd name="connsiteY0" fmla="*/ 1905 h 1022985"/>
              <a:gd name="connsiteX1" fmla="*/ 10568 w 117248"/>
              <a:gd name="connsiteY1" fmla="*/ 0 h 1022985"/>
              <a:gd name="connsiteX2" fmla="*/ 20093 w 117248"/>
              <a:gd name="connsiteY2" fmla="*/ 1003935 h 1022985"/>
              <a:gd name="connsiteX3" fmla="*/ 117248 w 117248"/>
              <a:gd name="connsiteY3" fmla="*/ 1022985 h 1022985"/>
              <a:gd name="connsiteX0" fmla="*/ 111533 w 117248"/>
              <a:gd name="connsiteY0" fmla="*/ 1905 h 1025061"/>
              <a:gd name="connsiteX1" fmla="*/ 10568 w 117248"/>
              <a:gd name="connsiteY1" fmla="*/ 0 h 1025061"/>
              <a:gd name="connsiteX2" fmla="*/ 20093 w 117248"/>
              <a:gd name="connsiteY2" fmla="*/ 1024890 h 1025061"/>
              <a:gd name="connsiteX3" fmla="*/ 117248 w 117248"/>
              <a:gd name="connsiteY3" fmla="*/ 1022985 h 1025061"/>
              <a:gd name="connsiteX0" fmla="*/ 111533 w 117248"/>
              <a:gd name="connsiteY0" fmla="*/ 1905 h 1023320"/>
              <a:gd name="connsiteX1" fmla="*/ 10568 w 117248"/>
              <a:gd name="connsiteY1" fmla="*/ 0 h 1023320"/>
              <a:gd name="connsiteX2" fmla="*/ 20093 w 117248"/>
              <a:gd name="connsiteY2" fmla="*/ 1022985 h 1023320"/>
              <a:gd name="connsiteX3" fmla="*/ 117248 w 117248"/>
              <a:gd name="connsiteY3" fmla="*/ 1022985 h 1023320"/>
              <a:gd name="connsiteX0" fmla="*/ 100965 w 106680"/>
              <a:gd name="connsiteY0" fmla="*/ 1905 h 1023320"/>
              <a:gd name="connsiteX1" fmla="*/ 0 w 106680"/>
              <a:gd name="connsiteY1" fmla="*/ 0 h 1023320"/>
              <a:gd name="connsiteX2" fmla="*/ 9525 w 106680"/>
              <a:gd name="connsiteY2" fmla="*/ 1022985 h 1023320"/>
              <a:gd name="connsiteX3" fmla="*/ 106680 w 106680"/>
              <a:gd name="connsiteY3" fmla="*/ 1022985 h 1023320"/>
              <a:gd name="connsiteX0" fmla="*/ 100965 w 106680"/>
              <a:gd name="connsiteY0" fmla="*/ 0 h 1021415"/>
              <a:gd name="connsiteX1" fmla="*/ 0 w 106680"/>
              <a:gd name="connsiteY1" fmla="*/ 3810 h 1021415"/>
              <a:gd name="connsiteX2" fmla="*/ 9525 w 106680"/>
              <a:gd name="connsiteY2" fmla="*/ 1021080 h 1021415"/>
              <a:gd name="connsiteX3" fmla="*/ 106680 w 106680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60 w 104775"/>
              <a:gd name="connsiteY0" fmla="*/ 0 h 1021415"/>
              <a:gd name="connsiteX1" fmla="*/ 0 w 104775"/>
              <a:gd name="connsiteY1" fmla="*/ 3810 h 1021415"/>
              <a:gd name="connsiteX2" fmla="*/ 7620 w 104775"/>
              <a:gd name="connsiteY2" fmla="*/ 1021080 h 1021415"/>
              <a:gd name="connsiteX3" fmla="*/ 104775 w 104775"/>
              <a:gd name="connsiteY3" fmla="*/ 1021080 h 1021415"/>
              <a:gd name="connsiteX0" fmla="*/ 99074 w 104789"/>
              <a:gd name="connsiteY0" fmla="*/ 0 h 1021415"/>
              <a:gd name="connsiteX1" fmla="*/ 14 w 104789"/>
              <a:gd name="connsiteY1" fmla="*/ 3810 h 1021415"/>
              <a:gd name="connsiteX2" fmla="*/ 7634 w 104789"/>
              <a:gd name="connsiteY2" fmla="*/ 1021080 h 1021415"/>
              <a:gd name="connsiteX3" fmla="*/ 104789 w 104789"/>
              <a:gd name="connsiteY3" fmla="*/ 1021080 h 1021415"/>
              <a:gd name="connsiteX0" fmla="*/ 9529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9529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93393 w 101013"/>
              <a:gd name="connsiteY0" fmla="*/ 0 h 1019510"/>
              <a:gd name="connsiteX1" fmla="*/ 48 w 101013"/>
              <a:gd name="connsiteY1" fmla="*/ 3810 h 1019510"/>
              <a:gd name="connsiteX2" fmla="*/ 3858 w 101013"/>
              <a:gd name="connsiteY2" fmla="*/ 1019175 h 1019510"/>
              <a:gd name="connsiteX3" fmla="*/ 101013 w 101013"/>
              <a:gd name="connsiteY3" fmla="*/ 1019175 h 1019510"/>
              <a:gd name="connsiteX0" fmla="*/ 53388 w 101013"/>
              <a:gd name="connsiteY0" fmla="*/ 0 h 1021415"/>
              <a:gd name="connsiteX1" fmla="*/ 48 w 101013"/>
              <a:gd name="connsiteY1" fmla="*/ 5715 h 1021415"/>
              <a:gd name="connsiteX2" fmla="*/ 3858 w 101013"/>
              <a:gd name="connsiteY2" fmla="*/ 1021080 h 1021415"/>
              <a:gd name="connsiteX3" fmla="*/ 101013 w 101013"/>
              <a:gd name="connsiteY3" fmla="*/ 1021080 h 1021415"/>
              <a:gd name="connsiteX0" fmla="*/ 102918 w 102918"/>
              <a:gd name="connsiteY0" fmla="*/ 2300 h 1016095"/>
              <a:gd name="connsiteX1" fmla="*/ 48 w 102918"/>
              <a:gd name="connsiteY1" fmla="*/ 395 h 1016095"/>
              <a:gd name="connsiteX2" fmla="*/ 3858 w 102918"/>
              <a:gd name="connsiteY2" fmla="*/ 1015760 h 1016095"/>
              <a:gd name="connsiteX3" fmla="*/ 101013 w 102918"/>
              <a:gd name="connsiteY3" fmla="*/ 1015760 h 1016095"/>
              <a:gd name="connsiteX0" fmla="*/ 102918 w 102918"/>
              <a:gd name="connsiteY0" fmla="*/ 0 h 1017605"/>
              <a:gd name="connsiteX1" fmla="*/ 48 w 102918"/>
              <a:gd name="connsiteY1" fmla="*/ 1905 h 1017605"/>
              <a:gd name="connsiteX2" fmla="*/ 3858 w 102918"/>
              <a:gd name="connsiteY2" fmla="*/ 1017270 h 1017605"/>
              <a:gd name="connsiteX3" fmla="*/ 101013 w 102918"/>
              <a:gd name="connsiteY3" fmla="*/ 1017270 h 10176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2918" h="1017605">
                <a:moveTo>
                  <a:pt x="102918" y="0"/>
                </a:moveTo>
                <a:cubicBezTo>
                  <a:pt x="71168" y="1905"/>
                  <a:pt x="54658" y="0"/>
                  <a:pt x="48" y="1905"/>
                </a:cubicBezTo>
                <a:cubicBezTo>
                  <a:pt x="-270" y="113665"/>
                  <a:pt x="1000" y="846772"/>
                  <a:pt x="3858" y="1017270"/>
                </a:cubicBezTo>
                <a:cubicBezTo>
                  <a:pt x="61325" y="1018222"/>
                  <a:pt x="46879" y="1016793"/>
                  <a:pt x="101013" y="101727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66" name="Textfeld 2">
            <a:extLst>
              <a:ext uri="{FF2B5EF4-FFF2-40B4-BE49-F238E27FC236}">
                <a16:creationId xmlns:a16="http://schemas.microsoft.com/office/drawing/2014/main" id="{5417ED63-747B-CA1C-2741-0D77DBE3F8BA}"/>
              </a:ext>
            </a:extLst>
          </p:cNvPr>
          <p:cNvSpPr txBox="1"/>
          <p:nvPr/>
        </p:nvSpPr>
        <p:spPr>
          <a:xfrm>
            <a:off x="8269639" y="5757127"/>
            <a:ext cx="70920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167" name="Textfeld 2">
            <a:extLst>
              <a:ext uri="{FF2B5EF4-FFF2-40B4-BE49-F238E27FC236}">
                <a16:creationId xmlns:a16="http://schemas.microsoft.com/office/drawing/2014/main" id="{B83697ED-6036-6140-03AF-C22961895532}"/>
              </a:ext>
            </a:extLst>
          </p:cNvPr>
          <p:cNvSpPr txBox="1"/>
          <p:nvPr/>
        </p:nvSpPr>
        <p:spPr>
          <a:xfrm>
            <a:off x="8508211" y="5466150"/>
            <a:ext cx="70920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</a:p>
        </p:txBody>
      </p:sp>
      <p:sp>
        <p:nvSpPr>
          <p:cNvPr id="168" name="TextBox 1">
            <a:extLst>
              <a:ext uri="{FF2B5EF4-FFF2-40B4-BE49-F238E27FC236}">
                <a16:creationId xmlns:a16="http://schemas.microsoft.com/office/drawing/2014/main" id="{D8B8CBBA-6677-E0D5-E9B7-B71822AC1E1E}"/>
              </a:ext>
            </a:extLst>
          </p:cNvPr>
          <p:cNvSpPr txBox="1"/>
          <p:nvPr/>
        </p:nvSpPr>
        <p:spPr>
          <a:xfrm rot="16200000">
            <a:off x="9442027" y="7176483"/>
            <a:ext cx="78737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I &lt; 0.7</a:t>
            </a:r>
          </a:p>
        </p:txBody>
      </p:sp>
      <p:pic>
        <p:nvPicPr>
          <p:cNvPr id="169" name="Picture 168" descr="A picture containing text&#10;&#10;Description automatically generated">
            <a:extLst>
              <a:ext uri="{FF2B5EF4-FFF2-40B4-BE49-F238E27FC236}">
                <a16:creationId xmlns:a16="http://schemas.microsoft.com/office/drawing/2014/main" id="{C02D1DCD-3185-3660-2D69-65F795E6F4D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49" t="9465" r="33438" b="2847"/>
          <a:stretch/>
        </p:blipFill>
        <p:spPr>
          <a:xfrm>
            <a:off x="1403995" y="5714343"/>
            <a:ext cx="1532022" cy="3826042"/>
          </a:xfrm>
          <a:prstGeom prst="rect">
            <a:avLst/>
          </a:prstGeom>
        </p:spPr>
      </p:pic>
      <p:sp>
        <p:nvSpPr>
          <p:cNvPr id="170" name="TextBox 169">
            <a:extLst>
              <a:ext uri="{FF2B5EF4-FFF2-40B4-BE49-F238E27FC236}">
                <a16:creationId xmlns:a16="http://schemas.microsoft.com/office/drawing/2014/main" id="{045C9FB3-1369-B3A2-169E-4959660F5BDE}"/>
              </a:ext>
            </a:extLst>
          </p:cNvPr>
          <p:cNvSpPr txBox="1"/>
          <p:nvPr/>
        </p:nvSpPr>
        <p:spPr>
          <a:xfrm>
            <a:off x="1434821" y="5216404"/>
            <a:ext cx="15584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put    Pulldown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E0AFECFE-C56E-E790-7985-1B6DC7465C97}"/>
              </a:ext>
            </a:extLst>
          </p:cNvPr>
          <p:cNvSpPr txBox="1"/>
          <p:nvPr/>
        </p:nvSpPr>
        <p:spPr>
          <a:xfrm rot="5400000" flipH="1">
            <a:off x="2366751" y="7473718"/>
            <a:ext cx="15103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ly-ADP-ribose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E43FA9E0-EBC6-C0DF-75DE-7157566FE4AB}"/>
              </a:ext>
            </a:extLst>
          </p:cNvPr>
          <p:cNvSpPr txBox="1"/>
          <p:nvPr/>
        </p:nvSpPr>
        <p:spPr>
          <a:xfrm>
            <a:off x="1478695" y="5452406"/>
            <a:ext cx="1941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      +       -       +    PJ34</a:t>
            </a:r>
          </a:p>
        </p:txBody>
      </p:sp>
      <p:pic>
        <p:nvPicPr>
          <p:cNvPr id="173" name="Picture 172" descr="A picture containing text, businesscard&#10;&#10;Description automatically generated">
            <a:extLst>
              <a:ext uri="{FF2B5EF4-FFF2-40B4-BE49-F238E27FC236}">
                <a16:creationId xmlns:a16="http://schemas.microsoft.com/office/drawing/2014/main" id="{3000BC30-336C-61D2-E0B3-EBA94F7B471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705" t="22914" r="38910" b="63216"/>
          <a:stretch/>
        </p:blipFill>
        <p:spPr>
          <a:xfrm>
            <a:off x="1403994" y="10028825"/>
            <a:ext cx="1533600" cy="323329"/>
          </a:xfrm>
          <a:prstGeom prst="rect">
            <a:avLst/>
          </a:prstGeom>
        </p:spPr>
      </p:pic>
      <p:pic>
        <p:nvPicPr>
          <p:cNvPr id="174" name="Picture 173" descr="A picture containing text&#10;&#10;Description automatically generated">
            <a:extLst>
              <a:ext uri="{FF2B5EF4-FFF2-40B4-BE49-F238E27FC236}">
                <a16:creationId xmlns:a16="http://schemas.microsoft.com/office/drawing/2014/main" id="{B618EAE5-B391-A7BD-3B35-9D79F2C31B7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925" t="68944" r="35228" b="18101"/>
          <a:stretch/>
        </p:blipFill>
        <p:spPr>
          <a:xfrm>
            <a:off x="1402417" y="9683519"/>
            <a:ext cx="1533600" cy="290996"/>
          </a:xfrm>
          <a:prstGeom prst="rect">
            <a:avLst/>
          </a:prstGeom>
        </p:spPr>
      </p:pic>
      <p:sp>
        <p:nvSpPr>
          <p:cNvPr id="175" name="TextBox 174">
            <a:extLst>
              <a:ext uri="{FF2B5EF4-FFF2-40B4-BE49-F238E27FC236}">
                <a16:creationId xmlns:a16="http://schemas.microsoft.com/office/drawing/2014/main" id="{6EC4CDF1-7F12-1153-8E54-5EF9BE98104E}"/>
              </a:ext>
            </a:extLst>
          </p:cNvPr>
          <p:cNvSpPr txBox="1"/>
          <p:nvPr/>
        </p:nvSpPr>
        <p:spPr>
          <a:xfrm>
            <a:off x="2930638" y="9653906"/>
            <a:ext cx="8947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ERBP1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F147A1E5-6035-B543-EDD6-DD507F8F6E91}"/>
              </a:ext>
            </a:extLst>
          </p:cNvPr>
          <p:cNvSpPr txBox="1"/>
          <p:nvPr/>
        </p:nvSpPr>
        <p:spPr>
          <a:xfrm>
            <a:off x="2936017" y="10016765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5F90E884-01E5-0DC8-D081-EC8E9455DEE7}"/>
              </a:ext>
            </a:extLst>
          </p:cNvPr>
          <p:cNvSpPr txBox="1"/>
          <p:nvPr/>
        </p:nvSpPr>
        <p:spPr>
          <a:xfrm>
            <a:off x="328887" y="210049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3046E372-3F67-32EB-E3B9-FD933C6890CF}"/>
              </a:ext>
            </a:extLst>
          </p:cNvPr>
          <p:cNvSpPr txBox="1"/>
          <p:nvPr/>
        </p:nvSpPr>
        <p:spPr>
          <a:xfrm>
            <a:off x="328887" y="4627239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082BEFFD-E011-3718-B411-11D9FB3FDD66}"/>
              </a:ext>
            </a:extLst>
          </p:cNvPr>
          <p:cNvSpPr txBox="1"/>
          <p:nvPr/>
        </p:nvSpPr>
        <p:spPr>
          <a:xfrm>
            <a:off x="1036581" y="1004754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F69D1DDD-EE78-87CB-8C85-C880377B973B}"/>
              </a:ext>
            </a:extLst>
          </p:cNvPr>
          <p:cNvSpPr txBox="1"/>
          <p:nvPr/>
        </p:nvSpPr>
        <p:spPr>
          <a:xfrm>
            <a:off x="1045758" y="97102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789B6B6C-CF61-5E82-B68B-50FAF0CF29E2}"/>
              </a:ext>
            </a:extLst>
          </p:cNvPr>
          <p:cNvSpPr txBox="1"/>
          <p:nvPr/>
        </p:nvSpPr>
        <p:spPr>
          <a:xfrm>
            <a:off x="1051432" y="667810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70E19122-D152-028C-DB4C-B8FAD4880CD0}"/>
              </a:ext>
            </a:extLst>
          </p:cNvPr>
          <p:cNvSpPr txBox="1"/>
          <p:nvPr/>
        </p:nvSpPr>
        <p:spPr>
          <a:xfrm>
            <a:off x="1046467" y="699214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F877AD2D-1DDA-CB63-006E-E268A489523A}"/>
              </a:ext>
            </a:extLst>
          </p:cNvPr>
          <p:cNvSpPr txBox="1"/>
          <p:nvPr/>
        </p:nvSpPr>
        <p:spPr>
          <a:xfrm>
            <a:off x="1047126" y="749700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4058D3CC-0396-AD8C-868C-23CE0EB263A0}"/>
              </a:ext>
            </a:extLst>
          </p:cNvPr>
          <p:cNvSpPr txBox="1"/>
          <p:nvPr/>
        </p:nvSpPr>
        <p:spPr>
          <a:xfrm>
            <a:off x="1045897" y="815001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447764F9-D5C1-5FFD-BEB1-CEE2B128BBE2}"/>
              </a:ext>
            </a:extLst>
          </p:cNvPr>
          <p:cNvSpPr txBox="1"/>
          <p:nvPr/>
        </p:nvSpPr>
        <p:spPr>
          <a:xfrm>
            <a:off x="1064197" y="88077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3AD31030-1C11-A526-B1A2-DE74147945A8}"/>
              </a:ext>
            </a:extLst>
          </p:cNvPr>
          <p:cNvSpPr txBox="1"/>
          <p:nvPr/>
        </p:nvSpPr>
        <p:spPr>
          <a:xfrm>
            <a:off x="971880" y="635174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DF3B123D-F688-CE55-DE90-4AFA5240DC4D}"/>
              </a:ext>
            </a:extLst>
          </p:cNvPr>
          <p:cNvSpPr txBox="1"/>
          <p:nvPr/>
        </p:nvSpPr>
        <p:spPr>
          <a:xfrm>
            <a:off x="974873" y="60726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EB929E18-C66A-FD85-1B1C-E88AADEA7B04}"/>
              </a:ext>
            </a:extLst>
          </p:cNvPr>
          <p:cNvSpPr txBox="1"/>
          <p:nvPr/>
        </p:nvSpPr>
        <p:spPr>
          <a:xfrm>
            <a:off x="974060" y="583931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556F9049-3843-2E53-71F2-BD24F7CCBA80}"/>
              </a:ext>
            </a:extLst>
          </p:cNvPr>
          <p:cNvSpPr txBox="1"/>
          <p:nvPr/>
        </p:nvSpPr>
        <p:spPr>
          <a:xfrm>
            <a:off x="959495" y="562565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grpSp>
        <p:nvGrpSpPr>
          <p:cNvPr id="190" name="Gruppieren 27">
            <a:extLst>
              <a:ext uri="{FF2B5EF4-FFF2-40B4-BE49-F238E27FC236}">
                <a16:creationId xmlns:a16="http://schemas.microsoft.com/office/drawing/2014/main" id="{81DCB1B6-570C-DB44-AE91-AEC4CFA6DAD7}"/>
              </a:ext>
            </a:extLst>
          </p:cNvPr>
          <p:cNvGrpSpPr/>
          <p:nvPr/>
        </p:nvGrpSpPr>
        <p:grpSpPr>
          <a:xfrm>
            <a:off x="589504" y="505123"/>
            <a:ext cx="9700972" cy="3831956"/>
            <a:chOff x="5492440" y="264632"/>
            <a:chExt cx="9700972" cy="3831956"/>
          </a:xfrm>
        </p:grpSpPr>
        <p:sp>
          <p:nvSpPr>
            <p:cNvPr id="191" name="TextBox 10">
              <a:extLst>
                <a:ext uri="{FF2B5EF4-FFF2-40B4-BE49-F238E27FC236}">
                  <a16:creationId xmlns:a16="http://schemas.microsoft.com/office/drawing/2014/main" id="{904637D4-6905-3E19-4C19-422797076B52}"/>
                </a:ext>
              </a:extLst>
            </p:cNvPr>
            <p:cNvSpPr txBox="1"/>
            <p:nvPr/>
          </p:nvSpPr>
          <p:spPr>
            <a:xfrm>
              <a:off x="6570255" y="264632"/>
              <a:ext cx="80220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ERBP1                            PARP                                merge                              DAPI</a:t>
              </a:r>
            </a:p>
          </p:txBody>
        </p:sp>
        <p:sp>
          <p:nvSpPr>
            <p:cNvPr id="192" name="TextBox 11">
              <a:extLst>
                <a:ext uri="{FF2B5EF4-FFF2-40B4-BE49-F238E27FC236}">
                  <a16:creationId xmlns:a16="http://schemas.microsoft.com/office/drawing/2014/main" id="{41E0A690-8E6D-D247-13A3-0A61C83877DD}"/>
                </a:ext>
              </a:extLst>
            </p:cNvPr>
            <p:cNvSpPr txBox="1"/>
            <p:nvPr/>
          </p:nvSpPr>
          <p:spPr>
            <a:xfrm rot="16200000">
              <a:off x="5217851" y="1317358"/>
              <a:ext cx="9140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93" name="TextBox 13">
              <a:extLst>
                <a:ext uri="{FF2B5EF4-FFF2-40B4-BE49-F238E27FC236}">
                  <a16:creationId xmlns:a16="http://schemas.microsoft.com/office/drawing/2014/main" id="{1D852D1B-A82D-826A-C078-81FD4FDD062A}"/>
                </a:ext>
              </a:extLst>
            </p:cNvPr>
            <p:cNvSpPr txBox="1"/>
            <p:nvPr/>
          </p:nvSpPr>
          <p:spPr>
            <a:xfrm rot="16200000">
              <a:off x="5315423" y="3106059"/>
              <a:ext cx="6925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pic>
          <p:nvPicPr>
            <p:cNvPr id="194" name="Picture 3">
              <a:extLst>
                <a:ext uri="{FF2B5EF4-FFF2-40B4-BE49-F238E27FC236}">
                  <a16:creationId xmlns:a16="http://schemas.microsoft.com/office/drawing/2014/main" id="{52DECBE0-9C8C-169E-DC18-66B342ECADA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5862431" y="619577"/>
              <a:ext cx="2268000" cy="1694483"/>
            </a:xfrm>
            <a:prstGeom prst="rect">
              <a:avLst/>
            </a:prstGeom>
          </p:spPr>
        </p:pic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D510616A-9212-A2C8-C321-65A246C661F7}"/>
                </a:ext>
              </a:extLst>
            </p:cNvPr>
            <p:cNvSpPr txBox="1"/>
            <p:nvPr/>
          </p:nvSpPr>
          <p:spPr>
            <a:xfrm>
              <a:off x="7606747" y="1972290"/>
              <a:ext cx="5421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µm</a:t>
              </a:r>
            </a:p>
          </p:txBody>
        </p:sp>
        <p:pic>
          <p:nvPicPr>
            <p:cNvPr id="196" name="Picture 4">
              <a:extLst>
                <a:ext uri="{FF2B5EF4-FFF2-40B4-BE49-F238E27FC236}">
                  <a16:creationId xmlns:a16="http://schemas.microsoft.com/office/drawing/2014/main" id="{6E629195-D8CC-8F29-DB47-F8DC320FF5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8216758" y="619577"/>
              <a:ext cx="2268000" cy="1694483"/>
            </a:xfrm>
            <a:prstGeom prst="rect">
              <a:avLst/>
            </a:prstGeom>
          </p:spPr>
        </p:pic>
        <p:pic>
          <p:nvPicPr>
            <p:cNvPr id="197" name="Picture 5">
              <a:extLst>
                <a:ext uri="{FF2B5EF4-FFF2-40B4-BE49-F238E27FC236}">
                  <a16:creationId xmlns:a16="http://schemas.microsoft.com/office/drawing/2014/main" id="{719564A2-9FDC-93A2-B59D-95F9FE93B3B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10571085" y="619576"/>
              <a:ext cx="2268000" cy="1694483"/>
            </a:xfrm>
            <a:prstGeom prst="rect">
              <a:avLst/>
            </a:prstGeom>
          </p:spPr>
        </p:pic>
        <p:pic>
          <p:nvPicPr>
            <p:cNvPr id="198" name="Picture 2" descr="E:\8522 U251 SERBP1 PARP\H2O2 10m\2\both.jpg">
              <a:extLst>
                <a:ext uri="{FF2B5EF4-FFF2-40B4-BE49-F238E27FC236}">
                  <a16:creationId xmlns:a16="http://schemas.microsoft.com/office/drawing/2014/main" id="{AA05D995-8983-DBD8-77B4-1212D42282E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571085" y="2402105"/>
              <a:ext cx="2268000" cy="16944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9" name="Picture 3" descr="E:\8522 U251 SERBP1 PARP\H2O2 10m\2\p.jpg">
              <a:extLst>
                <a:ext uri="{FF2B5EF4-FFF2-40B4-BE49-F238E27FC236}">
                  <a16:creationId xmlns:a16="http://schemas.microsoft.com/office/drawing/2014/main" id="{A3C71662-3D61-B352-A9A2-7415383EC7E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216758" y="2402104"/>
              <a:ext cx="2268000" cy="16944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0" name="Picture 4" descr="E:\8522 U251 SERBP1 PARP\H2O2 10m\2\s.jpg">
              <a:extLst>
                <a:ext uri="{FF2B5EF4-FFF2-40B4-BE49-F238E27FC236}">
                  <a16:creationId xmlns:a16="http://schemas.microsoft.com/office/drawing/2014/main" id="{F7D8AF26-32F8-C193-8CA7-5F61E54D746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62431" y="2402104"/>
              <a:ext cx="2268000" cy="16944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1" name="TextBox 3">
              <a:extLst>
                <a:ext uri="{FF2B5EF4-FFF2-40B4-BE49-F238E27FC236}">
                  <a16:creationId xmlns:a16="http://schemas.microsoft.com/office/drawing/2014/main" id="{E5D4B3B3-2E17-57CE-C851-52AA1642D15F}"/>
                </a:ext>
              </a:extLst>
            </p:cNvPr>
            <p:cNvSpPr txBox="1"/>
            <p:nvPr/>
          </p:nvSpPr>
          <p:spPr>
            <a:xfrm>
              <a:off x="7606747" y="3745625"/>
              <a:ext cx="5421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µm</a:t>
              </a:r>
            </a:p>
          </p:txBody>
        </p:sp>
        <p:pic>
          <p:nvPicPr>
            <p:cNvPr id="202" name="Picture 2" descr="E:\8522 U251 SERBP1 PARP\ctl\2\d.jpg">
              <a:extLst>
                <a:ext uri="{FF2B5EF4-FFF2-40B4-BE49-F238E27FC236}">
                  <a16:creationId xmlns:a16="http://schemas.microsoft.com/office/drawing/2014/main" id="{43DB2C01-4059-2A51-0544-EB2B3E995E1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V="1">
              <a:off x="12925412" y="619576"/>
              <a:ext cx="2268000" cy="16944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3" name="Picture 3" descr="E:\8522 U251 SERBP1 PARP\H2O2 10m\2\d.jpg">
              <a:extLst>
                <a:ext uri="{FF2B5EF4-FFF2-40B4-BE49-F238E27FC236}">
                  <a16:creationId xmlns:a16="http://schemas.microsoft.com/office/drawing/2014/main" id="{CE79479D-5251-7F92-627C-693643F58E8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25412" y="2402104"/>
              <a:ext cx="2268000" cy="16944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04" name="Gerader Verbinder 2">
              <a:extLst>
                <a:ext uri="{FF2B5EF4-FFF2-40B4-BE49-F238E27FC236}">
                  <a16:creationId xmlns:a16="http://schemas.microsoft.com/office/drawing/2014/main" id="{C7B87BB2-BEEB-8613-A223-261C8C3B1BE7}"/>
                </a:ext>
              </a:extLst>
            </p:cNvPr>
            <p:cNvCxnSpPr/>
            <p:nvPr/>
          </p:nvCxnSpPr>
          <p:spPr>
            <a:xfrm>
              <a:off x="7744615" y="2215077"/>
              <a:ext cx="2664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Gerader Verbinder 25">
              <a:extLst>
                <a:ext uri="{FF2B5EF4-FFF2-40B4-BE49-F238E27FC236}">
                  <a16:creationId xmlns:a16="http://schemas.microsoft.com/office/drawing/2014/main" id="{7B08E3E9-0000-3C8E-259D-52F1FFFA86B0}"/>
                </a:ext>
              </a:extLst>
            </p:cNvPr>
            <p:cNvCxnSpPr/>
            <p:nvPr/>
          </p:nvCxnSpPr>
          <p:spPr>
            <a:xfrm>
              <a:off x="7744615" y="3991548"/>
              <a:ext cx="2664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6" name="TextBox 205">
            <a:extLst>
              <a:ext uri="{FF2B5EF4-FFF2-40B4-BE49-F238E27FC236}">
                <a16:creationId xmlns:a16="http://schemas.microsoft.com/office/drawing/2014/main" id="{9A29FFDE-AF7F-9E07-2D12-8CACC76F5D91}"/>
              </a:ext>
            </a:extLst>
          </p:cNvPr>
          <p:cNvSpPr txBox="1"/>
          <p:nvPr/>
        </p:nvSpPr>
        <p:spPr>
          <a:xfrm>
            <a:off x="3338702" y="462723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195885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</TotalTime>
  <Words>62</Words>
  <Application>Microsoft Office PowerPoint</Application>
  <PresentationFormat>Custom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Theme</vt:lpstr>
      <vt:lpstr>PowerPoint Presentation</vt:lpstr>
    </vt:vector>
  </TitlesOfParts>
  <Company>UT Health San Antoni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alva, Luiz O</dc:creator>
  <cp:lastModifiedBy>Penalva, Luiz O</cp:lastModifiedBy>
  <cp:revision>19</cp:revision>
  <dcterms:created xsi:type="dcterms:W3CDTF">2023-03-13T15:23:17Z</dcterms:created>
  <dcterms:modified xsi:type="dcterms:W3CDTF">2024-02-20T20:37:13Z</dcterms:modified>
</cp:coreProperties>
</file>